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61" r:id="rId5"/>
    <p:sldId id="262" r:id="rId6"/>
    <p:sldId id="263" r:id="rId7"/>
    <p:sldId id="259" r:id="rId8"/>
    <p:sldId id="260" r:id="rId9"/>
    <p:sldId id="264" r:id="rId10"/>
    <p:sldId id="265" r:id="rId11"/>
    <p:sldId id="266" r:id="rId12"/>
    <p:sldId id="267" r:id="rId13"/>
  </p:sldIdLst>
  <p:sldSz cx="8120063" cy="10826750" type="B4ISO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1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E39A6DF-FC9C-41E1-8AAB-2C66DCB14955}" v="10" dt="2025-08-09T16:33:44.44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29" d="100"/>
          <a:sy n="129" d="100"/>
        </p:scale>
        <p:origin x="108" y="181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ei Zhang" userId="b4d8b0095ebc413d" providerId="LiveId" clId="{A5E1A199-527C-4978-81E9-89D1567DD12B}"/>
    <pc:docChg chg="undo custSel modSld sldOrd">
      <pc:chgData name="Fei Zhang" userId="b4d8b0095ebc413d" providerId="LiveId" clId="{A5E1A199-527C-4978-81E9-89D1567DD12B}" dt="2025-08-10T08:07:20.912" v="32" actId="114"/>
      <pc:docMkLst>
        <pc:docMk/>
      </pc:docMkLst>
      <pc:sldChg chg="modSp mod">
        <pc:chgData name="Fei Zhang" userId="b4d8b0095ebc413d" providerId="LiveId" clId="{A5E1A199-527C-4978-81E9-89D1567DD12B}" dt="2025-08-10T07:24:01.394" v="9" actId="6549"/>
        <pc:sldMkLst>
          <pc:docMk/>
          <pc:sldMk cId="2185338036" sldId="256"/>
        </pc:sldMkLst>
        <pc:spChg chg="mod">
          <ac:chgData name="Fei Zhang" userId="b4d8b0095ebc413d" providerId="LiveId" clId="{A5E1A199-527C-4978-81E9-89D1567DD12B}" dt="2025-08-10T07:24:01.394" v="9" actId="6549"/>
          <ac:spMkLst>
            <pc:docMk/>
            <pc:sldMk cId="2185338036" sldId="256"/>
            <ac:spMk id="6" creationId="{22C05008-44CB-1AE4-449F-88F91547BD37}"/>
          </ac:spMkLst>
        </pc:spChg>
      </pc:sldChg>
      <pc:sldChg chg="modSp mod">
        <pc:chgData name="Fei Zhang" userId="b4d8b0095ebc413d" providerId="LiveId" clId="{A5E1A199-527C-4978-81E9-89D1567DD12B}" dt="2025-08-10T07:24:06.927" v="12" actId="6549"/>
        <pc:sldMkLst>
          <pc:docMk/>
          <pc:sldMk cId="459858381" sldId="257"/>
        </pc:sldMkLst>
        <pc:spChg chg="mod">
          <ac:chgData name="Fei Zhang" userId="b4d8b0095ebc413d" providerId="LiveId" clId="{A5E1A199-527C-4978-81E9-89D1567DD12B}" dt="2025-08-10T07:24:06.927" v="12" actId="6549"/>
          <ac:spMkLst>
            <pc:docMk/>
            <pc:sldMk cId="459858381" sldId="257"/>
            <ac:spMk id="6" creationId="{318F20AB-2A85-BC3B-926E-DD892C5D7146}"/>
          </ac:spMkLst>
        </pc:spChg>
      </pc:sldChg>
      <pc:sldChg chg="modSp mod">
        <pc:chgData name="Fei Zhang" userId="b4d8b0095ebc413d" providerId="LiveId" clId="{A5E1A199-527C-4978-81E9-89D1567DD12B}" dt="2025-08-10T07:24:11.308" v="15" actId="6549"/>
        <pc:sldMkLst>
          <pc:docMk/>
          <pc:sldMk cId="3042014729" sldId="258"/>
        </pc:sldMkLst>
        <pc:spChg chg="mod">
          <ac:chgData name="Fei Zhang" userId="b4d8b0095ebc413d" providerId="LiveId" clId="{A5E1A199-527C-4978-81E9-89D1567DD12B}" dt="2025-08-10T07:24:11.308" v="15" actId="6549"/>
          <ac:spMkLst>
            <pc:docMk/>
            <pc:sldMk cId="3042014729" sldId="258"/>
            <ac:spMk id="4" creationId="{DED08D3D-C0F3-3827-0C67-8925EEB56750}"/>
          </ac:spMkLst>
        </pc:spChg>
      </pc:sldChg>
      <pc:sldChg chg="modSp mod">
        <pc:chgData name="Fei Zhang" userId="b4d8b0095ebc413d" providerId="LiveId" clId="{A5E1A199-527C-4978-81E9-89D1567DD12B}" dt="2025-08-10T07:26:36.438" v="23" actId="20577"/>
        <pc:sldMkLst>
          <pc:docMk/>
          <pc:sldMk cId="1284394464" sldId="259"/>
        </pc:sldMkLst>
        <pc:spChg chg="mod">
          <ac:chgData name="Fei Zhang" userId="b4d8b0095ebc413d" providerId="LiveId" clId="{A5E1A199-527C-4978-81E9-89D1567DD12B}" dt="2025-08-10T07:26:36.438" v="23" actId="20577"/>
          <ac:spMkLst>
            <pc:docMk/>
            <pc:sldMk cId="1284394464" sldId="259"/>
            <ac:spMk id="4" creationId="{74878D4E-2387-D5ED-DE26-AAD8B43C8666}"/>
          </ac:spMkLst>
        </pc:spChg>
      </pc:sldChg>
      <pc:sldChg chg="modSp mod">
        <pc:chgData name="Fei Zhang" userId="b4d8b0095ebc413d" providerId="LiveId" clId="{A5E1A199-527C-4978-81E9-89D1567DD12B}" dt="2025-08-10T07:26:41.197" v="24" actId="20577"/>
        <pc:sldMkLst>
          <pc:docMk/>
          <pc:sldMk cId="103572169" sldId="260"/>
        </pc:sldMkLst>
        <pc:spChg chg="mod">
          <ac:chgData name="Fei Zhang" userId="b4d8b0095ebc413d" providerId="LiveId" clId="{A5E1A199-527C-4978-81E9-89D1567DD12B}" dt="2025-08-10T07:26:41.197" v="24" actId="20577"/>
          <ac:spMkLst>
            <pc:docMk/>
            <pc:sldMk cId="103572169" sldId="260"/>
            <ac:spMk id="4" creationId="{41AEAB2D-96E6-0C27-C604-941A44406231}"/>
          </ac:spMkLst>
        </pc:spChg>
      </pc:sldChg>
      <pc:sldChg chg="modSp mod">
        <pc:chgData name="Fei Zhang" userId="b4d8b0095ebc413d" providerId="LiveId" clId="{A5E1A199-527C-4978-81E9-89D1567DD12B}" dt="2025-08-10T07:24:14.758" v="18" actId="6549"/>
        <pc:sldMkLst>
          <pc:docMk/>
          <pc:sldMk cId="1585145115" sldId="261"/>
        </pc:sldMkLst>
        <pc:spChg chg="mod">
          <ac:chgData name="Fei Zhang" userId="b4d8b0095ebc413d" providerId="LiveId" clId="{A5E1A199-527C-4978-81E9-89D1567DD12B}" dt="2025-08-10T07:24:14.758" v="18" actId="6549"/>
          <ac:spMkLst>
            <pc:docMk/>
            <pc:sldMk cId="1585145115" sldId="261"/>
            <ac:spMk id="4" creationId="{250AD5A0-47BC-01F8-5DC9-471C6ECF1AD2}"/>
          </ac:spMkLst>
        </pc:spChg>
      </pc:sldChg>
      <pc:sldChg chg="modSp mod">
        <pc:chgData name="Fei Zhang" userId="b4d8b0095ebc413d" providerId="LiveId" clId="{A5E1A199-527C-4978-81E9-89D1567DD12B}" dt="2025-08-10T07:24:18.319" v="21" actId="6549"/>
        <pc:sldMkLst>
          <pc:docMk/>
          <pc:sldMk cId="2180278576" sldId="262"/>
        </pc:sldMkLst>
        <pc:spChg chg="mod">
          <ac:chgData name="Fei Zhang" userId="b4d8b0095ebc413d" providerId="LiveId" clId="{A5E1A199-527C-4978-81E9-89D1567DD12B}" dt="2025-08-10T07:24:18.319" v="21" actId="6549"/>
          <ac:spMkLst>
            <pc:docMk/>
            <pc:sldMk cId="2180278576" sldId="262"/>
            <ac:spMk id="4" creationId="{363E2BA5-6768-EEA2-54FD-0F9EF37D2FC9}"/>
          </ac:spMkLst>
        </pc:spChg>
      </pc:sldChg>
      <pc:sldChg chg="modSp mod">
        <pc:chgData name="Fei Zhang" userId="b4d8b0095ebc413d" providerId="LiveId" clId="{A5E1A199-527C-4978-81E9-89D1567DD12B}" dt="2025-08-10T07:26:29.921" v="22" actId="20577"/>
        <pc:sldMkLst>
          <pc:docMk/>
          <pc:sldMk cId="2787992721" sldId="263"/>
        </pc:sldMkLst>
        <pc:spChg chg="mod">
          <ac:chgData name="Fei Zhang" userId="b4d8b0095ebc413d" providerId="LiveId" clId="{A5E1A199-527C-4978-81E9-89D1567DD12B}" dt="2025-08-10T07:26:29.921" v="22" actId="20577"/>
          <ac:spMkLst>
            <pc:docMk/>
            <pc:sldMk cId="2787992721" sldId="263"/>
            <ac:spMk id="4" creationId="{D053E777-C954-BF07-C8BA-097FC15DA2C9}"/>
          </ac:spMkLst>
        </pc:spChg>
      </pc:sldChg>
      <pc:sldChg chg="modSp mod ord">
        <pc:chgData name="Fei Zhang" userId="b4d8b0095ebc413d" providerId="LiveId" clId="{A5E1A199-527C-4978-81E9-89D1567DD12B}" dt="2025-08-10T08:05:30.557" v="31" actId="114"/>
        <pc:sldMkLst>
          <pc:docMk/>
          <pc:sldMk cId="2580941554" sldId="264"/>
        </pc:sldMkLst>
        <pc:spChg chg="mod">
          <ac:chgData name="Fei Zhang" userId="b4d8b0095ebc413d" providerId="LiveId" clId="{A5E1A199-527C-4978-81E9-89D1567DD12B}" dt="2025-08-10T08:05:30.557" v="31" actId="114"/>
          <ac:spMkLst>
            <pc:docMk/>
            <pc:sldMk cId="2580941554" sldId="264"/>
            <ac:spMk id="44" creationId="{66D68AD7-044C-DC18-9AD6-F21D8E310596}"/>
          </ac:spMkLst>
        </pc:spChg>
      </pc:sldChg>
      <pc:sldChg chg="modSp mod">
        <pc:chgData name="Fei Zhang" userId="b4d8b0095ebc413d" providerId="LiveId" clId="{A5E1A199-527C-4978-81E9-89D1567DD12B}" dt="2025-08-10T07:26:52.776" v="26" actId="20577"/>
        <pc:sldMkLst>
          <pc:docMk/>
          <pc:sldMk cId="675844685" sldId="265"/>
        </pc:sldMkLst>
        <pc:spChg chg="mod">
          <ac:chgData name="Fei Zhang" userId="b4d8b0095ebc413d" providerId="LiveId" clId="{A5E1A199-527C-4978-81E9-89D1567DD12B}" dt="2025-08-10T07:26:52.776" v="26" actId="20577"/>
          <ac:spMkLst>
            <pc:docMk/>
            <pc:sldMk cId="675844685" sldId="265"/>
            <ac:spMk id="4" creationId="{F1E24BE7-77F0-A241-4DBD-9D44D7237939}"/>
          </ac:spMkLst>
        </pc:spChg>
      </pc:sldChg>
      <pc:sldChg chg="modSp mod">
        <pc:chgData name="Fei Zhang" userId="b4d8b0095ebc413d" providerId="LiveId" clId="{A5E1A199-527C-4978-81E9-89D1567DD12B}" dt="2025-08-10T08:07:20.912" v="32" actId="114"/>
        <pc:sldMkLst>
          <pc:docMk/>
          <pc:sldMk cId="2535241612" sldId="266"/>
        </pc:sldMkLst>
        <pc:spChg chg="mod">
          <ac:chgData name="Fei Zhang" userId="b4d8b0095ebc413d" providerId="LiveId" clId="{A5E1A199-527C-4978-81E9-89D1567DD12B}" dt="2025-08-10T08:07:20.912" v="32" actId="114"/>
          <ac:spMkLst>
            <pc:docMk/>
            <pc:sldMk cId="2535241612" sldId="266"/>
            <ac:spMk id="3" creationId="{F57D0F46-7362-4022-9317-7CB389F26D54}"/>
          </ac:spMkLst>
        </pc:spChg>
      </pc:sldChg>
      <pc:sldChg chg="modSp mod">
        <pc:chgData name="Fei Zhang" userId="b4d8b0095ebc413d" providerId="LiveId" clId="{A5E1A199-527C-4978-81E9-89D1567DD12B}" dt="2025-08-10T07:27:06.303" v="28" actId="20577"/>
        <pc:sldMkLst>
          <pc:docMk/>
          <pc:sldMk cId="2338148396" sldId="267"/>
        </pc:sldMkLst>
        <pc:spChg chg="mod">
          <ac:chgData name="Fei Zhang" userId="b4d8b0095ebc413d" providerId="LiveId" clId="{A5E1A199-527C-4978-81E9-89D1567DD12B}" dt="2025-08-10T07:27:06.303" v="28" actId="20577"/>
          <ac:spMkLst>
            <pc:docMk/>
            <pc:sldMk cId="2338148396" sldId="267"/>
            <ac:spMk id="4" creationId="{1A445D1D-C1E9-BA93-D060-9047BAF279E8}"/>
          </ac:spMkLst>
        </pc:spChg>
      </pc:sldChg>
    </pc:docChg>
  </pc:docChgLst>
  <pc:docChgLst>
    <pc:chgData name="Fei Zhang" userId="b4d8b0095ebc413d" providerId="LiveId" clId="{2E39A6DF-FC9C-41E1-8AAB-2C66DCB14955}"/>
    <pc:docChg chg="undo custSel modSld">
      <pc:chgData name="Fei Zhang" userId="b4d8b0095ebc413d" providerId="LiveId" clId="{2E39A6DF-FC9C-41E1-8AAB-2C66DCB14955}" dt="2025-08-09T16:33:59.818" v="34" actId="1076"/>
      <pc:docMkLst>
        <pc:docMk/>
      </pc:docMkLst>
      <pc:sldChg chg="addSp delSp modSp mod">
        <pc:chgData name="Fei Zhang" userId="b4d8b0095ebc413d" providerId="LiveId" clId="{2E39A6DF-FC9C-41E1-8AAB-2C66DCB14955}" dt="2025-08-09T16:33:59.818" v="34" actId="1076"/>
        <pc:sldMkLst>
          <pc:docMk/>
          <pc:sldMk cId="459858381" sldId="257"/>
        </pc:sldMkLst>
        <pc:spChg chg="del">
          <ac:chgData name="Fei Zhang" userId="b4d8b0095ebc413d" providerId="LiveId" clId="{2E39A6DF-FC9C-41E1-8AAB-2C66DCB14955}" dt="2025-08-09T16:33:49.261" v="32" actId="478"/>
          <ac:spMkLst>
            <pc:docMk/>
            <pc:sldMk cId="459858381" sldId="257"/>
            <ac:spMk id="2" creationId="{A72CAFDE-AC56-A7EE-F0AA-F9F118B53554}"/>
          </ac:spMkLst>
        </pc:spChg>
        <pc:spChg chg="del">
          <ac:chgData name="Fei Zhang" userId="b4d8b0095ebc413d" providerId="LiveId" clId="{2E39A6DF-FC9C-41E1-8AAB-2C66DCB14955}" dt="2025-08-09T16:33:49.261" v="32" actId="478"/>
          <ac:spMkLst>
            <pc:docMk/>
            <pc:sldMk cId="459858381" sldId="257"/>
            <ac:spMk id="3" creationId="{F345F342-04F1-51FB-752B-847E6483100B}"/>
          </ac:spMkLst>
        </pc:spChg>
        <pc:picChg chg="add mod">
          <ac:chgData name="Fei Zhang" userId="b4d8b0095ebc413d" providerId="LiveId" clId="{2E39A6DF-FC9C-41E1-8AAB-2C66DCB14955}" dt="2025-08-09T16:33:59.818" v="34" actId="1076"/>
          <ac:picMkLst>
            <pc:docMk/>
            <pc:sldMk cId="459858381" sldId="257"/>
            <ac:picMk id="4" creationId="{6902B8B1-5280-59FC-4434-7627759F3F05}"/>
          </ac:picMkLst>
        </pc:picChg>
        <pc:picChg chg="del mod">
          <ac:chgData name="Fei Zhang" userId="b4d8b0095ebc413d" providerId="LiveId" clId="{2E39A6DF-FC9C-41E1-8AAB-2C66DCB14955}" dt="2025-08-09T16:33:42.886" v="29" actId="478"/>
          <ac:picMkLst>
            <pc:docMk/>
            <pc:sldMk cId="459858381" sldId="257"/>
            <ac:picMk id="5" creationId="{10202A5D-277C-B6B9-2320-58CEABD98D0B}"/>
          </ac:picMkLst>
        </pc:picChg>
      </pc:sldChg>
      <pc:sldChg chg="addSp delSp modSp mod">
        <pc:chgData name="Fei Zhang" userId="b4d8b0095ebc413d" providerId="LiveId" clId="{2E39A6DF-FC9C-41E1-8AAB-2C66DCB14955}" dt="2025-08-09T16:10:46.530" v="27" actId="1076"/>
        <pc:sldMkLst>
          <pc:docMk/>
          <pc:sldMk cId="1284394464" sldId="259"/>
        </pc:sldMkLst>
        <pc:spChg chg="mod">
          <ac:chgData name="Fei Zhang" userId="b4d8b0095ebc413d" providerId="LiveId" clId="{2E39A6DF-FC9C-41E1-8AAB-2C66DCB14955}" dt="2025-08-09T16:10:33.722" v="24" actId="1076"/>
          <ac:spMkLst>
            <pc:docMk/>
            <pc:sldMk cId="1284394464" sldId="259"/>
            <ac:spMk id="4" creationId="{74878D4E-2387-D5ED-DE26-AAD8B43C8666}"/>
          </ac:spMkLst>
        </pc:spChg>
        <pc:picChg chg="add mod">
          <ac:chgData name="Fei Zhang" userId="b4d8b0095ebc413d" providerId="LiveId" clId="{2E39A6DF-FC9C-41E1-8AAB-2C66DCB14955}" dt="2025-08-09T16:10:46.530" v="27" actId="1076"/>
          <ac:picMkLst>
            <pc:docMk/>
            <pc:sldMk cId="1284394464" sldId="259"/>
            <ac:picMk id="2" creationId="{3DC07C83-ED59-3D58-BD0C-CF0CE8C3AE4D}"/>
          </ac:picMkLst>
        </pc:picChg>
        <pc:picChg chg="del">
          <ac:chgData name="Fei Zhang" userId="b4d8b0095ebc413d" providerId="LiveId" clId="{2E39A6DF-FC9C-41E1-8AAB-2C66DCB14955}" dt="2025-08-09T16:10:30.720" v="23" actId="478"/>
          <ac:picMkLst>
            <pc:docMk/>
            <pc:sldMk cId="1284394464" sldId="259"/>
            <ac:picMk id="3" creationId="{D1360501-DF4D-FE2B-2CF6-DDCC5DE2F66C}"/>
          </ac:picMkLst>
        </pc:picChg>
      </pc:sldChg>
      <pc:sldChg chg="addSp delSp modSp mod">
        <pc:chgData name="Fei Zhang" userId="b4d8b0095ebc413d" providerId="LiveId" clId="{2E39A6DF-FC9C-41E1-8AAB-2C66DCB14955}" dt="2025-08-09T16:05:00.234" v="17" actId="1076"/>
        <pc:sldMkLst>
          <pc:docMk/>
          <pc:sldMk cId="1585145115" sldId="261"/>
        </pc:sldMkLst>
        <pc:spChg chg="mod">
          <ac:chgData name="Fei Zhang" userId="b4d8b0095ebc413d" providerId="LiveId" clId="{2E39A6DF-FC9C-41E1-8AAB-2C66DCB14955}" dt="2025-08-09T13:41:42.112" v="0"/>
          <ac:spMkLst>
            <pc:docMk/>
            <pc:sldMk cId="1585145115" sldId="261"/>
            <ac:spMk id="10" creationId="{AEB6CB91-170F-0935-7E95-A141E9E4F3BF}"/>
          </ac:spMkLst>
        </pc:spChg>
        <pc:spChg chg="mod">
          <ac:chgData name="Fei Zhang" userId="b4d8b0095ebc413d" providerId="LiveId" clId="{2E39A6DF-FC9C-41E1-8AAB-2C66DCB14955}" dt="2025-08-09T13:41:42.112" v="0"/>
          <ac:spMkLst>
            <pc:docMk/>
            <pc:sldMk cId="1585145115" sldId="261"/>
            <ac:spMk id="11" creationId="{0362F26C-DC7F-A92F-802E-3E041D1E1143}"/>
          </ac:spMkLst>
        </pc:spChg>
        <pc:spChg chg="mod">
          <ac:chgData name="Fei Zhang" userId="b4d8b0095ebc413d" providerId="LiveId" clId="{2E39A6DF-FC9C-41E1-8AAB-2C66DCB14955}" dt="2025-08-09T13:41:42.112" v="0"/>
          <ac:spMkLst>
            <pc:docMk/>
            <pc:sldMk cId="1585145115" sldId="261"/>
            <ac:spMk id="14" creationId="{D2085F79-33F9-E1DD-A284-CAA56BD4020F}"/>
          </ac:spMkLst>
        </pc:spChg>
        <pc:spChg chg="mod">
          <ac:chgData name="Fei Zhang" userId="b4d8b0095ebc413d" providerId="LiveId" clId="{2E39A6DF-FC9C-41E1-8AAB-2C66DCB14955}" dt="2025-08-09T13:41:42.112" v="0"/>
          <ac:spMkLst>
            <pc:docMk/>
            <pc:sldMk cId="1585145115" sldId="261"/>
            <ac:spMk id="15" creationId="{B6461A2F-AAB9-F530-0A30-BF8A5B241518}"/>
          </ac:spMkLst>
        </pc:spChg>
        <pc:spChg chg="mod">
          <ac:chgData name="Fei Zhang" userId="b4d8b0095ebc413d" providerId="LiveId" clId="{2E39A6DF-FC9C-41E1-8AAB-2C66DCB14955}" dt="2025-08-09T13:41:42.112" v="0"/>
          <ac:spMkLst>
            <pc:docMk/>
            <pc:sldMk cId="1585145115" sldId="261"/>
            <ac:spMk id="17" creationId="{40968CD8-50FB-E71A-F189-514045C10A70}"/>
          </ac:spMkLst>
        </pc:spChg>
        <pc:spChg chg="mod">
          <ac:chgData name="Fei Zhang" userId="b4d8b0095ebc413d" providerId="LiveId" clId="{2E39A6DF-FC9C-41E1-8AAB-2C66DCB14955}" dt="2025-08-09T13:41:42.112" v="0"/>
          <ac:spMkLst>
            <pc:docMk/>
            <pc:sldMk cId="1585145115" sldId="261"/>
            <ac:spMk id="18" creationId="{CD70FCE9-C586-BBD3-F00C-DC966F9787A9}"/>
          </ac:spMkLst>
        </pc:spChg>
        <pc:spChg chg="mod">
          <ac:chgData name="Fei Zhang" userId="b4d8b0095ebc413d" providerId="LiveId" clId="{2E39A6DF-FC9C-41E1-8AAB-2C66DCB14955}" dt="2025-08-09T13:41:42.112" v="0"/>
          <ac:spMkLst>
            <pc:docMk/>
            <pc:sldMk cId="1585145115" sldId="261"/>
            <ac:spMk id="20" creationId="{9E26E012-0720-4E80-BE0B-497397870F25}"/>
          </ac:spMkLst>
        </pc:spChg>
        <pc:spChg chg="mod">
          <ac:chgData name="Fei Zhang" userId="b4d8b0095ebc413d" providerId="LiveId" clId="{2E39A6DF-FC9C-41E1-8AAB-2C66DCB14955}" dt="2025-08-09T13:41:42.112" v="0"/>
          <ac:spMkLst>
            <pc:docMk/>
            <pc:sldMk cId="1585145115" sldId="261"/>
            <ac:spMk id="21" creationId="{4C3E8CE7-2F72-886D-8AB9-DC876B685326}"/>
          </ac:spMkLst>
        </pc:spChg>
        <pc:spChg chg="mod">
          <ac:chgData name="Fei Zhang" userId="b4d8b0095ebc413d" providerId="LiveId" clId="{2E39A6DF-FC9C-41E1-8AAB-2C66DCB14955}" dt="2025-08-09T13:41:42.112" v="0"/>
          <ac:spMkLst>
            <pc:docMk/>
            <pc:sldMk cId="1585145115" sldId="261"/>
            <ac:spMk id="24" creationId="{4EF04CB8-22A5-5655-5695-17BE19E75086}"/>
          </ac:spMkLst>
        </pc:spChg>
        <pc:spChg chg="mod">
          <ac:chgData name="Fei Zhang" userId="b4d8b0095ebc413d" providerId="LiveId" clId="{2E39A6DF-FC9C-41E1-8AAB-2C66DCB14955}" dt="2025-08-09T13:41:42.112" v="0"/>
          <ac:spMkLst>
            <pc:docMk/>
            <pc:sldMk cId="1585145115" sldId="261"/>
            <ac:spMk id="25" creationId="{49ADE577-2412-31F2-4AEA-6E383C8E4543}"/>
          </ac:spMkLst>
        </pc:spChg>
        <pc:picChg chg="del">
          <ac:chgData name="Fei Zhang" userId="b4d8b0095ebc413d" providerId="LiveId" clId="{2E39A6DF-FC9C-41E1-8AAB-2C66DCB14955}" dt="2025-08-09T13:41:47.581" v="3" actId="478"/>
          <ac:picMkLst>
            <pc:docMk/>
            <pc:sldMk cId="1585145115" sldId="261"/>
            <ac:picMk id="5" creationId="{84914C7E-ABF7-A57E-0F16-A4404C1D0BE7}"/>
          </ac:picMkLst>
        </pc:picChg>
        <pc:picChg chg="add del mod">
          <ac:chgData name="Fei Zhang" userId="b4d8b0095ebc413d" providerId="LiveId" clId="{2E39A6DF-FC9C-41E1-8AAB-2C66DCB14955}" dt="2025-08-09T16:04:50.871" v="15" actId="478"/>
          <ac:picMkLst>
            <pc:docMk/>
            <pc:sldMk cId="1585145115" sldId="261"/>
            <ac:picMk id="27" creationId="{C1C8EA51-1CFD-0B8A-FEA2-C8BC1A44F575}"/>
          </ac:picMkLst>
        </pc:picChg>
        <pc:picChg chg="add del mod">
          <ac:chgData name="Fei Zhang" userId="b4d8b0095ebc413d" providerId="LiveId" clId="{2E39A6DF-FC9C-41E1-8AAB-2C66DCB14955}" dt="2025-08-09T16:04:50.871" v="15" actId="478"/>
          <ac:picMkLst>
            <pc:docMk/>
            <pc:sldMk cId="1585145115" sldId="261"/>
            <ac:picMk id="28" creationId="{EA806285-15B7-F473-FBCD-96C254BCFE0F}"/>
          </ac:picMkLst>
        </pc:picChg>
        <pc:picChg chg="add mod">
          <ac:chgData name="Fei Zhang" userId="b4d8b0095ebc413d" providerId="LiveId" clId="{2E39A6DF-FC9C-41E1-8AAB-2C66DCB14955}" dt="2025-08-09T16:05:00.234" v="17" actId="1076"/>
          <ac:picMkLst>
            <pc:docMk/>
            <pc:sldMk cId="1585145115" sldId="261"/>
            <ac:picMk id="29" creationId="{7ED093C5-3795-9AB1-BF99-C05A18FF42EE}"/>
          </ac:picMkLst>
        </pc:picChg>
      </pc:sldChg>
      <pc:sldChg chg="addSp delSp modSp mod">
        <pc:chgData name="Fei Zhang" userId="b4d8b0095ebc413d" providerId="LiveId" clId="{2E39A6DF-FC9C-41E1-8AAB-2C66DCB14955}" dt="2025-08-09T16:05:31.074" v="20" actId="1076"/>
        <pc:sldMkLst>
          <pc:docMk/>
          <pc:sldMk cId="2180278576" sldId="262"/>
        </pc:sldMkLst>
        <pc:picChg chg="add mod">
          <ac:chgData name="Fei Zhang" userId="b4d8b0095ebc413d" providerId="LiveId" clId="{2E39A6DF-FC9C-41E1-8AAB-2C66DCB14955}" dt="2025-08-09T16:04:06.267" v="11"/>
          <ac:picMkLst>
            <pc:docMk/>
            <pc:sldMk cId="2180278576" sldId="262"/>
            <ac:picMk id="2" creationId="{EC65892E-B691-4FD2-17C4-49D04711E3EF}"/>
          </ac:picMkLst>
        </pc:picChg>
        <pc:picChg chg="add mod">
          <ac:chgData name="Fei Zhang" userId="b4d8b0095ebc413d" providerId="LiveId" clId="{2E39A6DF-FC9C-41E1-8AAB-2C66DCB14955}" dt="2025-08-09T16:05:31.074" v="20" actId="1076"/>
          <ac:picMkLst>
            <pc:docMk/>
            <pc:sldMk cId="2180278576" sldId="262"/>
            <ac:picMk id="3" creationId="{84526EC4-514C-9EB5-B815-8F2AFBE3A16E}"/>
          </ac:picMkLst>
        </pc:picChg>
        <pc:picChg chg="del">
          <ac:chgData name="Fei Zhang" userId="b4d8b0095ebc413d" providerId="LiveId" clId="{2E39A6DF-FC9C-41E1-8AAB-2C66DCB14955}" dt="2025-08-09T16:05:13.606" v="19" actId="478"/>
          <ac:picMkLst>
            <pc:docMk/>
            <pc:sldMk cId="2180278576" sldId="262"/>
            <ac:picMk id="35" creationId="{5BEE7E26-F979-B81D-7E68-44A59BC88B16}"/>
          </ac:picMkLst>
        </pc:picChg>
      </pc:sldChg>
    </pc:docChg>
  </pc:docChgLst>
  <pc:docChgLst>
    <pc:chgData name="Fei Zhang" userId="b4d8b0095ebc413d" providerId="LiveId" clId="{604B9CCF-5DF5-40D5-BF31-06C25C443C1F}"/>
    <pc:docChg chg="undo custSel addSld modSld">
      <pc:chgData name="Fei Zhang" userId="b4d8b0095ebc413d" providerId="LiveId" clId="{604B9CCF-5DF5-40D5-BF31-06C25C443C1F}" dt="2024-12-25T14:15:49.434" v="2255" actId="20577"/>
      <pc:docMkLst>
        <pc:docMk/>
      </pc:docMkLst>
      <pc:sldChg chg="addSp delSp modSp new mod">
        <pc:chgData name="Fei Zhang" userId="b4d8b0095ebc413d" providerId="LiveId" clId="{604B9CCF-5DF5-40D5-BF31-06C25C443C1F}" dt="2024-12-25T14:07:14.045" v="1510" actId="113"/>
        <pc:sldMkLst>
          <pc:docMk/>
          <pc:sldMk cId="2185338036" sldId="256"/>
        </pc:sldMkLst>
      </pc:sldChg>
      <pc:sldChg chg="addSp delSp modSp new mod modClrScheme chgLayout">
        <pc:chgData name="Fei Zhang" userId="b4d8b0095ebc413d" providerId="LiveId" clId="{604B9CCF-5DF5-40D5-BF31-06C25C443C1F}" dt="2024-12-25T14:07:09.278" v="1509" actId="113"/>
        <pc:sldMkLst>
          <pc:docMk/>
          <pc:sldMk cId="459858381" sldId="257"/>
        </pc:sldMkLst>
      </pc:sldChg>
      <pc:sldChg chg="addSp modSp new mod">
        <pc:chgData name="Fei Zhang" userId="b4d8b0095ebc413d" providerId="LiveId" clId="{604B9CCF-5DF5-40D5-BF31-06C25C443C1F}" dt="2024-12-25T14:07:01.361" v="1507" actId="113"/>
        <pc:sldMkLst>
          <pc:docMk/>
          <pc:sldMk cId="3042014729" sldId="258"/>
        </pc:sldMkLst>
      </pc:sldChg>
      <pc:sldChg chg="addSp modSp new mod">
        <pc:chgData name="Fei Zhang" userId="b4d8b0095ebc413d" providerId="LiveId" clId="{604B9CCF-5DF5-40D5-BF31-06C25C443C1F}" dt="2024-12-25T14:09:51.950" v="1738" actId="313"/>
        <pc:sldMkLst>
          <pc:docMk/>
          <pc:sldMk cId="1284394464" sldId="259"/>
        </pc:sldMkLst>
      </pc:sldChg>
      <pc:sldChg chg="addSp modSp new mod">
        <pc:chgData name="Fei Zhang" userId="b4d8b0095ebc413d" providerId="LiveId" clId="{604B9CCF-5DF5-40D5-BF31-06C25C443C1F}" dt="2024-12-25T14:13:15.639" v="2032" actId="20577"/>
        <pc:sldMkLst>
          <pc:docMk/>
          <pc:sldMk cId="103572169" sldId="260"/>
        </pc:sldMkLst>
      </pc:sldChg>
      <pc:sldChg chg="addSp modSp new mod">
        <pc:chgData name="Fei Zhang" userId="b4d8b0095ebc413d" providerId="LiveId" clId="{604B9CCF-5DF5-40D5-BF31-06C25C443C1F}" dt="2024-12-25T14:13:18.739" v="2033" actId="20577"/>
        <pc:sldMkLst>
          <pc:docMk/>
          <pc:sldMk cId="1585145115" sldId="261"/>
        </pc:sldMkLst>
      </pc:sldChg>
      <pc:sldChg chg="addSp modSp new mod">
        <pc:chgData name="Fei Zhang" userId="b4d8b0095ebc413d" providerId="LiveId" clId="{604B9CCF-5DF5-40D5-BF31-06C25C443C1F}" dt="2024-12-25T14:14:52.517" v="2180" actId="1076"/>
        <pc:sldMkLst>
          <pc:docMk/>
          <pc:sldMk cId="2180278576" sldId="262"/>
        </pc:sldMkLst>
      </pc:sldChg>
      <pc:sldChg chg="addSp modSp new mod">
        <pc:chgData name="Fei Zhang" userId="b4d8b0095ebc413d" providerId="LiveId" clId="{604B9CCF-5DF5-40D5-BF31-06C25C443C1F}" dt="2024-12-25T14:15:49.434" v="2255" actId="20577"/>
        <pc:sldMkLst>
          <pc:docMk/>
          <pc:sldMk cId="2787992721" sldId="263"/>
        </pc:sldMkLst>
      </pc:sldChg>
    </pc:docChg>
  </pc:docChgLst>
  <pc:docChgLst>
    <pc:chgData name="Fei Zhang" userId="b4d8b0095ebc413d" providerId="LiveId" clId="{5CBE4DD5-B28A-4FA9-AF27-8EF7C486AD0C}"/>
    <pc:docChg chg="addSld modSld">
      <pc:chgData name="Fei Zhang" userId="b4d8b0095ebc413d" providerId="LiveId" clId="{5CBE4DD5-B28A-4FA9-AF27-8EF7C486AD0C}" dt="2025-03-20T05:36:56.867" v="1"/>
      <pc:docMkLst>
        <pc:docMk/>
      </pc:docMkLst>
      <pc:sldChg chg="addSp modSp new">
        <pc:chgData name="Fei Zhang" userId="b4d8b0095ebc413d" providerId="LiveId" clId="{5CBE4DD5-B28A-4FA9-AF27-8EF7C486AD0C}" dt="2025-03-20T05:36:56.867" v="1"/>
        <pc:sldMkLst>
          <pc:docMk/>
          <pc:sldMk cId="4143377320" sldId="264"/>
        </pc:sldMkLst>
      </pc:sldChg>
    </pc:docChg>
  </pc:docChgLst>
  <pc:docChgLst>
    <pc:chgData name="Fei Zhang" userId="b4d8b0095ebc413d" providerId="LiveId" clId="{CB5BA62D-4854-4BFC-8F5C-7BE5C67130CC}"/>
    <pc:docChg chg="undo custSel addSld delSld modSld sldOrd">
      <pc:chgData name="Fei Zhang" userId="b4d8b0095ebc413d" providerId="LiveId" clId="{CB5BA62D-4854-4BFC-8F5C-7BE5C67130CC}" dt="2025-05-12T13:11:34.746" v="214" actId="57"/>
      <pc:docMkLst>
        <pc:docMk/>
      </pc:docMkLst>
      <pc:sldChg chg="addSp modSp mod">
        <pc:chgData name="Fei Zhang" userId="b4d8b0095ebc413d" providerId="LiveId" clId="{CB5BA62D-4854-4BFC-8F5C-7BE5C67130CC}" dt="2025-05-08T12:45:18.847" v="28" actId="12789"/>
        <pc:sldMkLst>
          <pc:docMk/>
          <pc:sldMk cId="459858381" sldId="257"/>
        </pc:sldMkLst>
      </pc:sldChg>
      <pc:sldChg chg="modSp mod">
        <pc:chgData name="Fei Zhang" userId="b4d8b0095ebc413d" providerId="LiveId" clId="{CB5BA62D-4854-4BFC-8F5C-7BE5C67130CC}" dt="2025-05-08T12:50:54.149" v="43" actId="114"/>
        <pc:sldMkLst>
          <pc:docMk/>
          <pc:sldMk cId="103572169" sldId="260"/>
        </pc:sldMkLst>
      </pc:sldChg>
      <pc:sldChg chg="addSp delSp modSp mod">
        <pc:chgData name="Fei Zhang" userId="b4d8b0095ebc413d" providerId="LiveId" clId="{CB5BA62D-4854-4BFC-8F5C-7BE5C67130CC}" dt="2025-05-08T12:50:31.943" v="42" actId="1076"/>
        <pc:sldMkLst>
          <pc:docMk/>
          <pc:sldMk cId="1585145115" sldId="261"/>
        </pc:sldMkLst>
      </pc:sldChg>
      <pc:sldChg chg="addSp delSp modSp mod">
        <pc:chgData name="Fei Zhang" userId="b4d8b0095ebc413d" providerId="LiveId" clId="{CB5BA62D-4854-4BFC-8F5C-7BE5C67130CC}" dt="2025-05-08T12:52:01.907" v="46" actId="6549"/>
        <pc:sldMkLst>
          <pc:docMk/>
          <pc:sldMk cId="2180278576" sldId="262"/>
        </pc:sldMkLst>
      </pc:sldChg>
      <pc:sldChg chg="addSp modSp new mod ord">
        <pc:chgData name="Fei Zhang" userId="b4d8b0095ebc413d" providerId="LiveId" clId="{CB5BA62D-4854-4BFC-8F5C-7BE5C67130CC}" dt="2025-05-12T13:11:34.746" v="214" actId="57"/>
        <pc:sldMkLst>
          <pc:docMk/>
          <pc:sldMk cId="2580941554" sldId="264"/>
        </pc:sldMkLst>
      </pc:sldChg>
      <pc:sldChg chg="del">
        <pc:chgData name="Fei Zhang" userId="b4d8b0095ebc413d" providerId="LiveId" clId="{CB5BA62D-4854-4BFC-8F5C-7BE5C67130CC}" dt="2025-05-08T12:45:29.115" v="29" actId="47"/>
        <pc:sldMkLst>
          <pc:docMk/>
          <pc:sldMk cId="4143377320" sldId="264"/>
        </pc:sldMkLst>
      </pc:sldChg>
      <pc:sldChg chg="addSp modSp new mod">
        <pc:chgData name="Fei Zhang" userId="b4d8b0095ebc413d" providerId="LiveId" clId="{CB5BA62D-4854-4BFC-8F5C-7BE5C67130CC}" dt="2025-05-12T03:33:26.808" v="171" actId="114"/>
        <pc:sldMkLst>
          <pc:docMk/>
          <pc:sldMk cId="675844685" sldId="265"/>
        </pc:sldMkLst>
      </pc:sldChg>
      <pc:sldChg chg="addSp modSp new mod">
        <pc:chgData name="Fei Zhang" userId="b4d8b0095ebc413d" providerId="LiveId" clId="{CB5BA62D-4854-4BFC-8F5C-7BE5C67130CC}" dt="2025-05-12T08:07:08.286" v="191" actId="20577"/>
        <pc:sldMkLst>
          <pc:docMk/>
          <pc:sldMk cId="2535241612" sldId="266"/>
        </pc:sldMkLst>
      </pc:sldChg>
      <pc:sldChg chg="addSp modSp new mod">
        <pc:chgData name="Fei Zhang" userId="b4d8b0095ebc413d" providerId="LiveId" clId="{CB5BA62D-4854-4BFC-8F5C-7BE5C67130CC}" dt="2025-05-12T08:09:59.356" v="210" actId="1076"/>
        <pc:sldMkLst>
          <pc:docMk/>
          <pc:sldMk cId="2338148396" sldId="267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E00AB56-3754-8034-10CD-E4962D93B6E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015008" y="1771879"/>
            <a:ext cx="6090047" cy="3769313"/>
          </a:xfrm>
        </p:spPr>
        <p:txBody>
          <a:bodyPr anchor="b"/>
          <a:lstStyle>
            <a:lvl1pPr algn="ctr">
              <a:defRPr sz="9472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378A085A-8409-FF48-B4E8-00DAB07CA7C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015008" y="5686551"/>
            <a:ext cx="6090047" cy="2613958"/>
          </a:xfrm>
        </p:spPr>
        <p:txBody>
          <a:bodyPr/>
          <a:lstStyle>
            <a:lvl1pPr marL="0" indent="0" algn="ctr">
              <a:buNone/>
              <a:defRPr sz="3789"/>
            </a:lvl1pPr>
            <a:lvl2pPr marL="721782" indent="0" algn="ctr">
              <a:buNone/>
              <a:defRPr sz="3157"/>
            </a:lvl2pPr>
            <a:lvl3pPr marL="1443563" indent="0" algn="ctr">
              <a:buNone/>
              <a:defRPr sz="2842"/>
            </a:lvl3pPr>
            <a:lvl4pPr marL="2165345" indent="0" algn="ctr">
              <a:buNone/>
              <a:defRPr sz="2526"/>
            </a:lvl4pPr>
            <a:lvl5pPr marL="2887127" indent="0" algn="ctr">
              <a:buNone/>
              <a:defRPr sz="2526"/>
            </a:lvl5pPr>
            <a:lvl6pPr marL="3608908" indent="0" algn="ctr">
              <a:buNone/>
              <a:defRPr sz="2526"/>
            </a:lvl6pPr>
            <a:lvl7pPr marL="4330690" indent="0" algn="ctr">
              <a:buNone/>
              <a:defRPr sz="2526"/>
            </a:lvl7pPr>
            <a:lvl8pPr marL="5052471" indent="0" algn="ctr">
              <a:buNone/>
              <a:defRPr sz="2526"/>
            </a:lvl8pPr>
            <a:lvl9pPr marL="5774253" indent="0" algn="ctr">
              <a:buNone/>
              <a:defRPr sz="2526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ED58A81-61A3-2D80-57AF-E4D9A0C3BD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E6BCC-A104-4AF5-998B-A8AA5629C41E}" type="datetimeFigureOut">
              <a:rPr lang="zh-CN" altLang="en-US" smtClean="0"/>
              <a:t>2025/8/10/Sun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8CB1D1C-A8BB-4650-CF98-4D477D44D9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571D0AE-4A0D-13BE-FC48-4ECC18750F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D6B50-3456-413B-B1DC-C5CDA6399A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6970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D8FDC4C-69F4-4A3D-C57C-201A63F45D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8B25A62-C253-1A3A-C96C-2C7B5FB0E92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B52286D-7052-A6E5-C1E1-B33FF314BC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E6BCC-A104-4AF5-998B-A8AA5629C41E}" type="datetimeFigureOut">
              <a:rPr lang="zh-CN" altLang="en-US" smtClean="0"/>
              <a:t>2025/8/10/Sun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2049782-AA2D-7C23-C625-44DF4A0090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E02D24B-9C52-C220-6BA9-18355543FB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D6B50-3456-413B-B1DC-C5CDA6399A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379564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89AD6C98-580F-80E1-0CBD-BA8BB40EB9C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5810920" y="576424"/>
            <a:ext cx="1750889" cy="917517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DA80ED4-D7F6-068D-8989-0030575B58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558254" y="576424"/>
            <a:ext cx="5151165" cy="917517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9186BC3-66DE-2565-546C-29A2595D6A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E6BCC-A104-4AF5-998B-A8AA5629C41E}" type="datetimeFigureOut">
              <a:rPr lang="zh-CN" altLang="en-US" smtClean="0"/>
              <a:t>2025/8/10/Sun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AF5F114-97FE-97AD-14C8-0A06683CD6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7F61652-424D-97E5-2234-4BAC1372CD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D6B50-3456-413B-B1DC-C5CDA6399A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382608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3CE416E-BCAC-3EF4-D61C-70E39A5BD8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593C772-C691-8B6D-5668-8A84D8B1B77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87116D8-FA9B-7D40-B7D4-4EA90252A4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E6BCC-A104-4AF5-998B-A8AA5629C41E}" type="datetimeFigureOut">
              <a:rPr lang="zh-CN" altLang="en-US" smtClean="0"/>
              <a:t>2025/8/10/Sun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F336D72-E864-CF82-A97D-5931B810EC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719CF16-86F4-C7C6-DAE1-C47539C16D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D6B50-3456-413B-B1DC-C5CDA6399A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06846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28B1D8C-AAE2-BF0B-685A-4A434C258A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54025" y="2699171"/>
            <a:ext cx="7003554" cy="4503626"/>
          </a:xfrm>
        </p:spPr>
        <p:txBody>
          <a:bodyPr anchor="b"/>
          <a:lstStyle>
            <a:lvl1pPr>
              <a:defRPr sz="9472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5763FC7-153D-DD50-664B-4DB3C6AD89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554025" y="7245403"/>
            <a:ext cx="7003554" cy="2368351"/>
          </a:xfrm>
        </p:spPr>
        <p:txBody>
          <a:bodyPr/>
          <a:lstStyle>
            <a:lvl1pPr marL="0" indent="0">
              <a:buNone/>
              <a:defRPr sz="3789">
                <a:solidFill>
                  <a:schemeClr val="tx1">
                    <a:tint val="82000"/>
                  </a:schemeClr>
                </a:solidFill>
              </a:defRPr>
            </a:lvl1pPr>
            <a:lvl2pPr marL="721782" indent="0">
              <a:buNone/>
              <a:defRPr sz="3157">
                <a:solidFill>
                  <a:schemeClr val="tx1">
                    <a:tint val="82000"/>
                  </a:schemeClr>
                </a:solidFill>
              </a:defRPr>
            </a:lvl2pPr>
            <a:lvl3pPr marL="1443563" indent="0">
              <a:buNone/>
              <a:defRPr sz="2842">
                <a:solidFill>
                  <a:schemeClr val="tx1">
                    <a:tint val="82000"/>
                  </a:schemeClr>
                </a:solidFill>
              </a:defRPr>
            </a:lvl3pPr>
            <a:lvl4pPr marL="2165345" indent="0">
              <a:buNone/>
              <a:defRPr sz="2526">
                <a:solidFill>
                  <a:schemeClr val="tx1">
                    <a:tint val="82000"/>
                  </a:schemeClr>
                </a:solidFill>
              </a:defRPr>
            </a:lvl4pPr>
            <a:lvl5pPr marL="2887127" indent="0">
              <a:buNone/>
              <a:defRPr sz="2526">
                <a:solidFill>
                  <a:schemeClr val="tx1">
                    <a:tint val="82000"/>
                  </a:schemeClr>
                </a:solidFill>
              </a:defRPr>
            </a:lvl5pPr>
            <a:lvl6pPr marL="3608908" indent="0">
              <a:buNone/>
              <a:defRPr sz="2526">
                <a:solidFill>
                  <a:schemeClr val="tx1">
                    <a:tint val="82000"/>
                  </a:schemeClr>
                </a:solidFill>
              </a:defRPr>
            </a:lvl6pPr>
            <a:lvl7pPr marL="4330690" indent="0">
              <a:buNone/>
              <a:defRPr sz="2526">
                <a:solidFill>
                  <a:schemeClr val="tx1">
                    <a:tint val="82000"/>
                  </a:schemeClr>
                </a:solidFill>
              </a:defRPr>
            </a:lvl7pPr>
            <a:lvl8pPr marL="5052471" indent="0">
              <a:buNone/>
              <a:defRPr sz="2526">
                <a:solidFill>
                  <a:schemeClr val="tx1">
                    <a:tint val="82000"/>
                  </a:schemeClr>
                </a:solidFill>
              </a:defRPr>
            </a:lvl8pPr>
            <a:lvl9pPr marL="5774253" indent="0">
              <a:buNone/>
              <a:defRPr sz="2526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9E890F9-2847-5DC3-D598-CAAF83A33B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E6BCC-A104-4AF5-998B-A8AA5629C41E}" type="datetimeFigureOut">
              <a:rPr lang="zh-CN" altLang="en-US" smtClean="0"/>
              <a:t>2025/8/10/Sun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880E550-259E-378B-579D-DBE2394A37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F322DE0-5770-F680-B642-DD9083AC3A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D6B50-3456-413B-B1DC-C5CDA6399A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58090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EFF6128-13DF-C04E-DABA-9559E0BC50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635E15D-16A9-3538-055F-5DAE5EADD29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558254" y="2882121"/>
            <a:ext cx="3451027" cy="686947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A7171E9-37FA-0A8B-7452-175BF0A79A7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110782" y="2882121"/>
            <a:ext cx="3451027" cy="686947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06C0E5A-A891-B431-4B67-3D2EE0A1C2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E6BCC-A104-4AF5-998B-A8AA5629C41E}" type="datetimeFigureOut">
              <a:rPr lang="zh-CN" altLang="en-US" smtClean="0"/>
              <a:t>2025/8/10/Sun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8801195-F4CA-5DB5-BD03-7484C86308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D2FB7A0-37AF-3AC4-F454-0A9960D5D5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D6B50-3456-413B-B1DC-C5CDA6399A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68787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C6D7C33-3337-1A5D-A2D1-C683EF5B87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59312" y="576425"/>
            <a:ext cx="7003554" cy="2092671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BA8B35D-6E68-28A2-CC28-01878C6308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559312" y="2654058"/>
            <a:ext cx="3435167" cy="1300713"/>
          </a:xfrm>
        </p:spPr>
        <p:txBody>
          <a:bodyPr anchor="b"/>
          <a:lstStyle>
            <a:lvl1pPr marL="0" indent="0">
              <a:buNone/>
              <a:defRPr sz="3789" b="1"/>
            </a:lvl1pPr>
            <a:lvl2pPr marL="721782" indent="0">
              <a:buNone/>
              <a:defRPr sz="3157" b="1"/>
            </a:lvl2pPr>
            <a:lvl3pPr marL="1443563" indent="0">
              <a:buNone/>
              <a:defRPr sz="2842" b="1"/>
            </a:lvl3pPr>
            <a:lvl4pPr marL="2165345" indent="0">
              <a:buNone/>
              <a:defRPr sz="2526" b="1"/>
            </a:lvl4pPr>
            <a:lvl5pPr marL="2887127" indent="0">
              <a:buNone/>
              <a:defRPr sz="2526" b="1"/>
            </a:lvl5pPr>
            <a:lvl6pPr marL="3608908" indent="0">
              <a:buNone/>
              <a:defRPr sz="2526" b="1"/>
            </a:lvl6pPr>
            <a:lvl7pPr marL="4330690" indent="0">
              <a:buNone/>
              <a:defRPr sz="2526" b="1"/>
            </a:lvl7pPr>
            <a:lvl8pPr marL="5052471" indent="0">
              <a:buNone/>
              <a:defRPr sz="2526" b="1"/>
            </a:lvl8pPr>
            <a:lvl9pPr marL="5774253" indent="0">
              <a:buNone/>
              <a:defRPr sz="2526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658E79F-F6D1-5945-413D-37DCF75B7FA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559312" y="3954771"/>
            <a:ext cx="3435167" cy="581687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03A82CD5-991B-917F-0680-939E81595FF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110782" y="2654058"/>
            <a:ext cx="3452084" cy="1300713"/>
          </a:xfrm>
        </p:spPr>
        <p:txBody>
          <a:bodyPr anchor="b"/>
          <a:lstStyle>
            <a:lvl1pPr marL="0" indent="0">
              <a:buNone/>
              <a:defRPr sz="3789" b="1"/>
            </a:lvl1pPr>
            <a:lvl2pPr marL="721782" indent="0">
              <a:buNone/>
              <a:defRPr sz="3157" b="1"/>
            </a:lvl2pPr>
            <a:lvl3pPr marL="1443563" indent="0">
              <a:buNone/>
              <a:defRPr sz="2842" b="1"/>
            </a:lvl3pPr>
            <a:lvl4pPr marL="2165345" indent="0">
              <a:buNone/>
              <a:defRPr sz="2526" b="1"/>
            </a:lvl4pPr>
            <a:lvl5pPr marL="2887127" indent="0">
              <a:buNone/>
              <a:defRPr sz="2526" b="1"/>
            </a:lvl5pPr>
            <a:lvl6pPr marL="3608908" indent="0">
              <a:buNone/>
              <a:defRPr sz="2526" b="1"/>
            </a:lvl6pPr>
            <a:lvl7pPr marL="4330690" indent="0">
              <a:buNone/>
              <a:defRPr sz="2526" b="1"/>
            </a:lvl7pPr>
            <a:lvl8pPr marL="5052471" indent="0">
              <a:buNone/>
              <a:defRPr sz="2526" b="1"/>
            </a:lvl8pPr>
            <a:lvl9pPr marL="5774253" indent="0">
              <a:buNone/>
              <a:defRPr sz="2526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D4BBC2B4-195F-DA6C-0635-81E58E0E677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110782" y="3954771"/>
            <a:ext cx="3452084" cy="581687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F5B2618-82C1-68DA-FE57-CE94677D89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E6BCC-A104-4AF5-998B-A8AA5629C41E}" type="datetimeFigureOut">
              <a:rPr lang="zh-CN" altLang="en-US" smtClean="0"/>
              <a:t>2025/8/10/Sun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FE004767-958C-DF79-6AAC-9557911453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B15199E1-D747-D665-5134-A5602CF1F1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D6B50-3456-413B-B1DC-C5CDA6399A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09359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F0F8E80-A5F8-B4F9-8F90-DC57AC78F0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97201DBA-12CC-BCE4-51D4-3B64114EED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E6BCC-A104-4AF5-998B-A8AA5629C41E}" type="datetimeFigureOut">
              <a:rPr lang="zh-CN" altLang="en-US" smtClean="0"/>
              <a:t>2025/8/10/Sun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CEE5D8F7-B237-4705-D6A5-27E69F8715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8F1900DB-64BD-9336-0221-D82A73D1ED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D6B50-3456-413B-B1DC-C5CDA6399A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3840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82605B7-7881-E0D2-DD7D-6A13754610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E6BCC-A104-4AF5-998B-A8AA5629C41E}" type="datetimeFigureOut">
              <a:rPr lang="zh-CN" altLang="en-US" smtClean="0"/>
              <a:t>2025/8/10/Sun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6BFE1BAE-67C0-C610-C743-AB4CCC9C9A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759851E8-F910-00E2-132C-9A1AF57A81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D6B50-3456-413B-B1DC-C5CDA6399A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18378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20A1CB9-20E8-9EFD-8B39-413F1687FD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59313" y="721783"/>
            <a:ext cx="2618931" cy="2526242"/>
          </a:xfrm>
        </p:spPr>
        <p:txBody>
          <a:bodyPr anchor="b"/>
          <a:lstStyle>
            <a:lvl1pPr>
              <a:defRPr sz="5052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2F19BCC-E31C-90AC-0C3E-BA065B61224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452084" y="1558852"/>
            <a:ext cx="4110782" cy="7694010"/>
          </a:xfrm>
        </p:spPr>
        <p:txBody>
          <a:bodyPr/>
          <a:lstStyle>
            <a:lvl1pPr>
              <a:defRPr sz="5052"/>
            </a:lvl1pPr>
            <a:lvl2pPr>
              <a:defRPr sz="4420"/>
            </a:lvl2pPr>
            <a:lvl3pPr>
              <a:defRPr sz="3789"/>
            </a:lvl3pPr>
            <a:lvl4pPr>
              <a:defRPr sz="3157"/>
            </a:lvl4pPr>
            <a:lvl5pPr>
              <a:defRPr sz="3157"/>
            </a:lvl5pPr>
            <a:lvl6pPr>
              <a:defRPr sz="3157"/>
            </a:lvl6pPr>
            <a:lvl7pPr>
              <a:defRPr sz="3157"/>
            </a:lvl7pPr>
            <a:lvl8pPr>
              <a:defRPr sz="3157"/>
            </a:lvl8pPr>
            <a:lvl9pPr>
              <a:defRPr sz="315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31AE9C1-EF71-7F71-B526-E6AD385110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559313" y="3248025"/>
            <a:ext cx="2618931" cy="6017368"/>
          </a:xfrm>
        </p:spPr>
        <p:txBody>
          <a:bodyPr/>
          <a:lstStyle>
            <a:lvl1pPr marL="0" indent="0">
              <a:buNone/>
              <a:defRPr sz="2526"/>
            </a:lvl1pPr>
            <a:lvl2pPr marL="721782" indent="0">
              <a:buNone/>
              <a:defRPr sz="2210"/>
            </a:lvl2pPr>
            <a:lvl3pPr marL="1443563" indent="0">
              <a:buNone/>
              <a:defRPr sz="1894"/>
            </a:lvl3pPr>
            <a:lvl4pPr marL="2165345" indent="0">
              <a:buNone/>
              <a:defRPr sz="1579"/>
            </a:lvl4pPr>
            <a:lvl5pPr marL="2887127" indent="0">
              <a:buNone/>
              <a:defRPr sz="1579"/>
            </a:lvl5pPr>
            <a:lvl6pPr marL="3608908" indent="0">
              <a:buNone/>
              <a:defRPr sz="1579"/>
            </a:lvl6pPr>
            <a:lvl7pPr marL="4330690" indent="0">
              <a:buNone/>
              <a:defRPr sz="1579"/>
            </a:lvl7pPr>
            <a:lvl8pPr marL="5052471" indent="0">
              <a:buNone/>
              <a:defRPr sz="1579"/>
            </a:lvl8pPr>
            <a:lvl9pPr marL="5774253" indent="0">
              <a:buNone/>
              <a:defRPr sz="157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874AEE8-71A9-8026-EB80-8DC60DF6CA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E6BCC-A104-4AF5-998B-A8AA5629C41E}" type="datetimeFigureOut">
              <a:rPr lang="zh-CN" altLang="en-US" smtClean="0"/>
              <a:t>2025/8/10/Sun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E497122-5CB0-1E34-8000-B7480CB94B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9A83CE8-8B41-4AFD-A44C-4B9DB8A6E4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D6B50-3456-413B-B1DC-C5CDA6399A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36324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819F286-D823-559E-5605-E4314FC113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59313" y="721783"/>
            <a:ext cx="2618931" cy="2526242"/>
          </a:xfrm>
        </p:spPr>
        <p:txBody>
          <a:bodyPr anchor="b"/>
          <a:lstStyle>
            <a:lvl1pPr>
              <a:defRPr sz="5052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C4561C5E-88F8-F0FF-04B1-DE929F61C7E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452084" y="1558852"/>
            <a:ext cx="4110782" cy="7694010"/>
          </a:xfrm>
        </p:spPr>
        <p:txBody>
          <a:bodyPr/>
          <a:lstStyle>
            <a:lvl1pPr marL="0" indent="0">
              <a:buNone/>
              <a:defRPr sz="5052"/>
            </a:lvl1pPr>
            <a:lvl2pPr marL="721782" indent="0">
              <a:buNone/>
              <a:defRPr sz="4420"/>
            </a:lvl2pPr>
            <a:lvl3pPr marL="1443563" indent="0">
              <a:buNone/>
              <a:defRPr sz="3789"/>
            </a:lvl3pPr>
            <a:lvl4pPr marL="2165345" indent="0">
              <a:buNone/>
              <a:defRPr sz="3157"/>
            </a:lvl4pPr>
            <a:lvl5pPr marL="2887127" indent="0">
              <a:buNone/>
              <a:defRPr sz="3157"/>
            </a:lvl5pPr>
            <a:lvl6pPr marL="3608908" indent="0">
              <a:buNone/>
              <a:defRPr sz="3157"/>
            </a:lvl6pPr>
            <a:lvl7pPr marL="4330690" indent="0">
              <a:buNone/>
              <a:defRPr sz="3157"/>
            </a:lvl7pPr>
            <a:lvl8pPr marL="5052471" indent="0">
              <a:buNone/>
              <a:defRPr sz="3157"/>
            </a:lvl8pPr>
            <a:lvl9pPr marL="5774253" indent="0">
              <a:buNone/>
              <a:defRPr sz="3157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1F23119-7E19-4FD4-99DA-E33124182B4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559313" y="3248025"/>
            <a:ext cx="2618931" cy="6017368"/>
          </a:xfrm>
        </p:spPr>
        <p:txBody>
          <a:bodyPr/>
          <a:lstStyle>
            <a:lvl1pPr marL="0" indent="0">
              <a:buNone/>
              <a:defRPr sz="2526"/>
            </a:lvl1pPr>
            <a:lvl2pPr marL="721782" indent="0">
              <a:buNone/>
              <a:defRPr sz="2210"/>
            </a:lvl2pPr>
            <a:lvl3pPr marL="1443563" indent="0">
              <a:buNone/>
              <a:defRPr sz="1894"/>
            </a:lvl3pPr>
            <a:lvl4pPr marL="2165345" indent="0">
              <a:buNone/>
              <a:defRPr sz="1579"/>
            </a:lvl4pPr>
            <a:lvl5pPr marL="2887127" indent="0">
              <a:buNone/>
              <a:defRPr sz="1579"/>
            </a:lvl5pPr>
            <a:lvl6pPr marL="3608908" indent="0">
              <a:buNone/>
              <a:defRPr sz="1579"/>
            </a:lvl6pPr>
            <a:lvl7pPr marL="4330690" indent="0">
              <a:buNone/>
              <a:defRPr sz="1579"/>
            </a:lvl7pPr>
            <a:lvl8pPr marL="5052471" indent="0">
              <a:buNone/>
              <a:defRPr sz="1579"/>
            </a:lvl8pPr>
            <a:lvl9pPr marL="5774253" indent="0">
              <a:buNone/>
              <a:defRPr sz="157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FB94904-7642-C5B7-9FE7-47A36C3643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E6BCC-A104-4AF5-998B-A8AA5629C41E}" type="datetimeFigureOut">
              <a:rPr lang="zh-CN" altLang="en-US" smtClean="0"/>
              <a:t>2025/8/10/Sun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9801D54-6B64-4C63-DCB9-EC2DD2FC23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3DA4FE2-17F9-5D8A-5495-652B042FB9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D6B50-3456-413B-B1DC-C5CDA6399A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99363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231D2970-77C9-E1CB-D772-C903DA5E85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58255" y="576425"/>
            <a:ext cx="7003554" cy="209267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167CD9B-A1D7-F923-B948-6032B9FE78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558255" y="2882121"/>
            <a:ext cx="7003554" cy="686947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5D6B2CB-E495-13A0-D5FD-FB2DE87A669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558254" y="10034794"/>
            <a:ext cx="1827014" cy="57642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94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EBE6BCC-A104-4AF5-998B-A8AA5629C41E}" type="datetimeFigureOut">
              <a:rPr lang="zh-CN" altLang="en-US" smtClean="0"/>
              <a:t>2025/8/10/Sun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CE849DD-4DB5-A7CC-BA72-107FCF7480B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689771" y="10034794"/>
            <a:ext cx="2740521" cy="57642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94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31E485F-2C7E-5224-212D-496CF42A16B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5734795" y="10034794"/>
            <a:ext cx="1827014" cy="57642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94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2BD6B50-3456-413B-B1DC-C5CDA6399A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332613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443563" rtl="0" eaLnBrk="1" latinLnBrk="0" hangingPunct="1">
        <a:lnSpc>
          <a:spcPct val="90000"/>
        </a:lnSpc>
        <a:spcBef>
          <a:spcPct val="0"/>
        </a:spcBef>
        <a:buNone/>
        <a:defRPr sz="694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60891" indent="-360891" algn="l" defTabSz="1443563" rtl="0" eaLnBrk="1" latinLnBrk="0" hangingPunct="1">
        <a:lnSpc>
          <a:spcPct val="90000"/>
        </a:lnSpc>
        <a:spcBef>
          <a:spcPts val="1579"/>
        </a:spcBef>
        <a:buFont typeface="Arial" panose="020B0604020202020204" pitchFamily="34" charset="0"/>
        <a:buChar char="•"/>
        <a:defRPr sz="4420" kern="1200">
          <a:solidFill>
            <a:schemeClr val="tx1"/>
          </a:solidFill>
          <a:latin typeface="+mn-lt"/>
          <a:ea typeface="+mn-ea"/>
          <a:cs typeface="+mn-cs"/>
        </a:defRPr>
      </a:lvl1pPr>
      <a:lvl2pPr marL="1082672" indent="-360891" algn="l" defTabSz="1443563" rtl="0" eaLnBrk="1" latinLnBrk="0" hangingPunct="1">
        <a:lnSpc>
          <a:spcPct val="90000"/>
        </a:lnSpc>
        <a:spcBef>
          <a:spcPts val="789"/>
        </a:spcBef>
        <a:buFont typeface="Arial" panose="020B0604020202020204" pitchFamily="34" charset="0"/>
        <a:buChar char="•"/>
        <a:defRPr sz="3789" kern="1200">
          <a:solidFill>
            <a:schemeClr val="tx1"/>
          </a:solidFill>
          <a:latin typeface="+mn-lt"/>
          <a:ea typeface="+mn-ea"/>
          <a:cs typeface="+mn-cs"/>
        </a:defRPr>
      </a:lvl2pPr>
      <a:lvl3pPr marL="1804454" indent="-360891" algn="l" defTabSz="1443563" rtl="0" eaLnBrk="1" latinLnBrk="0" hangingPunct="1">
        <a:lnSpc>
          <a:spcPct val="90000"/>
        </a:lnSpc>
        <a:spcBef>
          <a:spcPts val="789"/>
        </a:spcBef>
        <a:buFont typeface="Arial" panose="020B0604020202020204" pitchFamily="34" charset="0"/>
        <a:buChar char="•"/>
        <a:defRPr sz="3157" kern="1200">
          <a:solidFill>
            <a:schemeClr val="tx1"/>
          </a:solidFill>
          <a:latin typeface="+mn-lt"/>
          <a:ea typeface="+mn-ea"/>
          <a:cs typeface="+mn-cs"/>
        </a:defRPr>
      </a:lvl3pPr>
      <a:lvl4pPr marL="2526236" indent="-360891" algn="l" defTabSz="1443563" rtl="0" eaLnBrk="1" latinLnBrk="0" hangingPunct="1">
        <a:lnSpc>
          <a:spcPct val="90000"/>
        </a:lnSpc>
        <a:spcBef>
          <a:spcPts val="789"/>
        </a:spcBef>
        <a:buFont typeface="Arial" panose="020B0604020202020204" pitchFamily="34" charset="0"/>
        <a:buChar char="•"/>
        <a:defRPr sz="2842" kern="1200">
          <a:solidFill>
            <a:schemeClr val="tx1"/>
          </a:solidFill>
          <a:latin typeface="+mn-lt"/>
          <a:ea typeface="+mn-ea"/>
          <a:cs typeface="+mn-cs"/>
        </a:defRPr>
      </a:lvl4pPr>
      <a:lvl5pPr marL="3248017" indent="-360891" algn="l" defTabSz="1443563" rtl="0" eaLnBrk="1" latinLnBrk="0" hangingPunct="1">
        <a:lnSpc>
          <a:spcPct val="90000"/>
        </a:lnSpc>
        <a:spcBef>
          <a:spcPts val="789"/>
        </a:spcBef>
        <a:buFont typeface="Arial" panose="020B0604020202020204" pitchFamily="34" charset="0"/>
        <a:buChar char="•"/>
        <a:defRPr sz="2842" kern="1200">
          <a:solidFill>
            <a:schemeClr val="tx1"/>
          </a:solidFill>
          <a:latin typeface="+mn-lt"/>
          <a:ea typeface="+mn-ea"/>
          <a:cs typeface="+mn-cs"/>
        </a:defRPr>
      </a:lvl5pPr>
      <a:lvl6pPr marL="3969799" indent="-360891" algn="l" defTabSz="1443563" rtl="0" eaLnBrk="1" latinLnBrk="0" hangingPunct="1">
        <a:lnSpc>
          <a:spcPct val="90000"/>
        </a:lnSpc>
        <a:spcBef>
          <a:spcPts val="789"/>
        </a:spcBef>
        <a:buFont typeface="Arial" panose="020B0604020202020204" pitchFamily="34" charset="0"/>
        <a:buChar char="•"/>
        <a:defRPr sz="2842" kern="1200">
          <a:solidFill>
            <a:schemeClr val="tx1"/>
          </a:solidFill>
          <a:latin typeface="+mn-lt"/>
          <a:ea typeface="+mn-ea"/>
          <a:cs typeface="+mn-cs"/>
        </a:defRPr>
      </a:lvl6pPr>
      <a:lvl7pPr marL="4691581" indent="-360891" algn="l" defTabSz="1443563" rtl="0" eaLnBrk="1" latinLnBrk="0" hangingPunct="1">
        <a:lnSpc>
          <a:spcPct val="90000"/>
        </a:lnSpc>
        <a:spcBef>
          <a:spcPts val="789"/>
        </a:spcBef>
        <a:buFont typeface="Arial" panose="020B0604020202020204" pitchFamily="34" charset="0"/>
        <a:buChar char="•"/>
        <a:defRPr sz="2842" kern="1200">
          <a:solidFill>
            <a:schemeClr val="tx1"/>
          </a:solidFill>
          <a:latin typeface="+mn-lt"/>
          <a:ea typeface="+mn-ea"/>
          <a:cs typeface="+mn-cs"/>
        </a:defRPr>
      </a:lvl7pPr>
      <a:lvl8pPr marL="5413362" indent="-360891" algn="l" defTabSz="1443563" rtl="0" eaLnBrk="1" latinLnBrk="0" hangingPunct="1">
        <a:lnSpc>
          <a:spcPct val="90000"/>
        </a:lnSpc>
        <a:spcBef>
          <a:spcPts val="789"/>
        </a:spcBef>
        <a:buFont typeface="Arial" panose="020B0604020202020204" pitchFamily="34" charset="0"/>
        <a:buChar char="•"/>
        <a:defRPr sz="2842" kern="1200">
          <a:solidFill>
            <a:schemeClr val="tx1"/>
          </a:solidFill>
          <a:latin typeface="+mn-lt"/>
          <a:ea typeface="+mn-ea"/>
          <a:cs typeface="+mn-cs"/>
        </a:defRPr>
      </a:lvl8pPr>
      <a:lvl9pPr marL="6135144" indent="-360891" algn="l" defTabSz="1443563" rtl="0" eaLnBrk="1" latinLnBrk="0" hangingPunct="1">
        <a:lnSpc>
          <a:spcPct val="90000"/>
        </a:lnSpc>
        <a:spcBef>
          <a:spcPts val="789"/>
        </a:spcBef>
        <a:buFont typeface="Arial" panose="020B0604020202020204" pitchFamily="34" charset="0"/>
        <a:buChar char="•"/>
        <a:defRPr sz="284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443563" rtl="0" eaLnBrk="1" latinLnBrk="0" hangingPunct="1">
        <a:defRPr sz="2842" kern="1200">
          <a:solidFill>
            <a:schemeClr val="tx1"/>
          </a:solidFill>
          <a:latin typeface="+mn-lt"/>
          <a:ea typeface="+mn-ea"/>
          <a:cs typeface="+mn-cs"/>
        </a:defRPr>
      </a:lvl1pPr>
      <a:lvl2pPr marL="721782" algn="l" defTabSz="1443563" rtl="0" eaLnBrk="1" latinLnBrk="0" hangingPunct="1">
        <a:defRPr sz="2842" kern="1200">
          <a:solidFill>
            <a:schemeClr val="tx1"/>
          </a:solidFill>
          <a:latin typeface="+mn-lt"/>
          <a:ea typeface="+mn-ea"/>
          <a:cs typeface="+mn-cs"/>
        </a:defRPr>
      </a:lvl2pPr>
      <a:lvl3pPr marL="1443563" algn="l" defTabSz="1443563" rtl="0" eaLnBrk="1" latinLnBrk="0" hangingPunct="1">
        <a:defRPr sz="2842" kern="1200">
          <a:solidFill>
            <a:schemeClr val="tx1"/>
          </a:solidFill>
          <a:latin typeface="+mn-lt"/>
          <a:ea typeface="+mn-ea"/>
          <a:cs typeface="+mn-cs"/>
        </a:defRPr>
      </a:lvl3pPr>
      <a:lvl4pPr marL="2165345" algn="l" defTabSz="1443563" rtl="0" eaLnBrk="1" latinLnBrk="0" hangingPunct="1">
        <a:defRPr sz="2842" kern="1200">
          <a:solidFill>
            <a:schemeClr val="tx1"/>
          </a:solidFill>
          <a:latin typeface="+mn-lt"/>
          <a:ea typeface="+mn-ea"/>
          <a:cs typeface="+mn-cs"/>
        </a:defRPr>
      </a:lvl4pPr>
      <a:lvl5pPr marL="2887127" algn="l" defTabSz="1443563" rtl="0" eaLnBrk="1" latinLnBrk="0" hangingPunct="1">
        <a:defRPr sz="2842" kern="1200">
          <a:solidFill>
            <a:schemeClr val="tx1"/>
          </a:solidFill>
          <a:latin typeface="+mn-lt"/>
          <a:ea typeface="+mn-ea"/>
          <a:cs typeface="+mn-cs"/>
        </a:defRPr>
      </a:lvl5pPr>
      <a:lvl6pPr marL="3608908" algn="l" defTabSz="1443563" rtl="0" eaLnBrk="1" latinLnBrk="0" hangingPunct="1">
        <a:defRPr sz="2842" kern="1200">
          <a:solidFill>
            <a:schemeClr val="tx1"/>
          </a:solidFill>
          <a:latin typeface="+mn-lt"/>
          <a:ea typeface="+mn-ea"/>
          <a:cs typeface="+mn-cs"/>
        </a:defRPr>
      </a:lvl6pPr>
      <a:lvl7pPr marL="4330690" algn="l" defTabSz="1443563" rtl="0" eaLnBrk="1" latinLnBrk="0" hangingPunct="1">
        <a:defRPr sz="2842" kern="1200">
          <a:solidFill>
            <a:schemeClr val="tx1"/>
          </a:solidFill>
          <a:latin typeface="+mn-lt"/>
          <a:ea typeface="+mn-ea"/>
          <a:cs typeface="+mn-cs"/>
        </a:defRPr>
      </a:lvl7pPr>
      <a:lvl8pPr marL="5052471" algn="l" defTabSz="1443563" rtl="0" eaLnBrk="1" latinLnBrk="0" hangingPunct="1">
        <a:defRPr sz="2842" kern="1200">
          <a:solidFill>
            <a:schemeClr val="tx1"/>
          </a:solidFill>
          <a:latin typeface="+mn-lt"/>
          <a:ea typeface="+mn-ea"/>
          <a:cs typeface="+mn-cs"/>
        </a:defRPr>
      </a:lvl8pPr>
      <a:lvl9pPr marL="5774253" algn="l" defTabSz="1443563" rtl="0" eaLnBrk="1" latinLnBrk="0" hangingPunct="1">
        <a:defRPr sz="284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图示&#10;&#10;中度可信度描述已自动生成">
            <a:extLst>
              <a:ext uri="{FF2B5EF4-FFF2-40B4-BE49-F238E27FC236}">
                <a16:creationId xmlns:a16="http://schemas.microsoft.com/office/drawing/2014/main" id="{9880039F-682A-1341-4ADA-F67EA8BBF06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1317" y="2295094"/>
            <a:ext cx="7278041" cy="3303848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22C05008-44CB-1AE4-449F-88F91547BD37}"/>
              </a:ext>
            </a:extLst>
          </p:cNvPr>
          <p:cNvSpPr txBox="1"/>
          <p:nvPr/>
        </p:nvSpPr>
        <p:spPr>
          <a:xfrm>
            <a:off x="435723" y="5598942"/>
            <a:ext cx="64781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+mj-lt"/>
              </a:rPr>
              <a:t>Fig S1. The schematic of likelihood ratio test to detect SSET genes. </a:t>
            </a:r>
            <a:endParaRPr lang="zh-CN" altLang="en-US" sz="1400" b="1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218533803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BE17A0FD-6CD9-6790-5BA8-96400EED854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7499" y="2064869"/>
            <a:ext cx="6578974" cy="5007793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F1E24BE7-77F0-A241-4DBD-9D44D7237939}"/>
              </a:ext>
            </a:extLst>
          </p:cNvPr>
          <p:cNvSpPr txBox="1"/>
          <p:nvPr/>
        </p:nvSpPr>
        <p:spPr>
          <a:xfrm>
            <a:off x="666514" y="7339950"/>
            <a:ext cx="6930040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b="1" dirty="0">
                <a:latin typeface="+mj-lt"/>
              </a:rPr>
              <a:t>Fig S10. Na</a:t>
            </a:r>
            <a:r>
              <a:rPr lang="en-US" altLang="zh-CN" sz="1400" b="1" baseline="30000" dirty="0">
                <a:latin typeface="+mj-lt"/>
              </a:rPr>
              <a:t>+</a:t>
            </a:r>
            <a:r>
              <a:rPr lang="en-US" altLang="zh-CN" sz="1400" b="1" dirty="0">
                <a:latin typeface="+mj-lt"/>
              </a:rPr>
              <a:t> levels, K</a:t>
            </a:r>
            <a:r>
              <a:rPr lang="en-US" altLang="zh-CN" sz="1400" b="1" baseline="30000" dirty="0">
                <a:latin typeface="+mj-lt"/>
              </a:rPr>
              <a:t>+</a:t>
            </a:r>
            <a:r>
              <a:rPr lang="en-US" altLang="zh-CN" sz="1400" b="1" dirty="0">
                <a:latin typeface="+mj-lt"/>
              </a:rPr>
              <a:t> levels, and Na</a:t>
            </a:r>
            <a:r>
              <a:rPr lang="en-US" altLang="zh-CN" sz="1400" b="1" baseline="30000" dirty="0">
                <a:latin typeface="+mj-lt"/>
              </a:rPr>
              <a:t>+</a:t>
            </a:r>
            <a:r>
              <a:rPr lang="en-US" altLang="zh-CN" sz="1400" b="1" dirty="0">
                <a:latin typeface="+mj-lt"/>
              </a:rPr>
              <a:t>/K</a:t>
            </a:r>
            <a:r>
              <a:rPr lang="en-US" altLang="zh-CN" sz="1400" b="1" baseline="30000" dirty="0">
                <a:latin typeface="+mj-lt"/>
              </a:rPr>
              <a:t>+</a:t>
            </a:r>
            <a:r>
              <a:rPr lang="en-US" altLang="zh-CN" sz="1400" b="1" dirty="0">
                <a:latin typeface="+mj-lt"/>
              </a:rPr>
              <a:t> ratio change between </a:t>
            </a:r>
            <a:r>
              <a:rPr lang="en-US" altLang="zh-CN" sz="1400" b="1" i="1" dirty="0">
                <a:latin typeface="+mj-lt"/>
              </a:rPr>
              <a:t>gln2</a:t>
            </a:r>
            <a:r>
              <a:rPr lang="en-US" altLang="zh-CN" sz="1400" b="1" dirty="0">
                <a:latin typeface="+mj-lt"/>
              </a:rPr>
              <a:t> mutants and wild-type plants under CK (a-c) and salt stress (d-f) conditions. </a:t>
            </a:r>
            <a:r>
              <a:rPr lang="en-US" altLang="zh-CN" sz="1400" dirty="0">
                <a:latin typeface="+mj-lt"/>
              </a:rPr>
              <a:t>Error bar: stand deviation; Statistical significance was determined by two-sided t-test. * </a:t>
            </a:r>
            <a:r>
              <a:rPr lang="en-US" altLang="zh-CN" sz="1400" i="1" dirty="0">
                <a:latin typeface="+mj-lt"/>
              </a:rPr>
              <a:t>P</a:t>
            </a:r>
            <a:r>
              <a:rPr lang="en-US" altLang="zh-CN" sz="1400" dirty="0">
                <a:latin typeface="+mj-lt"/>
              </a:rPr>
              <a:t> &lt; 0.05; **, </a:t>
            </a:r>
            <a:r>
              <a:rPr lang="en-US" altLang="zh-CN" sz="1400" i="1" dirty="0">
                <a:latin typeface="+mj-lt"/>
              </a:rPr>
              <a:t>P</a:t>
            </a:r>
            <a:r>
              <a:rPr lang="en-US" altLang="zh-CN" sz="1400" dirty="0">
                <a:latin typeface="+mj-lt"/>
              </a:rPr>
              <a:t> &lt; 0.01.</a:t>
            </a:r>
            <a:endParaRPr lang="zh-CN" altLang="en-US" sz="1400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67584468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4B770343-6754-E347-115D-1DCDCA11D35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56220" y="2962859"/>
            <a:ext cx="5407621" cy="4651651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F57D0F46-7362-4022-9317-7CB389F26D54}"/>
              </a:ext>
            </a:extLst>
          </p:cNvPr>
          <p:cNvSpPr txBox="1"/>
          <p:nvPr/>
        </p:nvSpPr>
        <p:spPr>
          <a:xfrm>
            <a:off x="832768" y="8036141"/>
            <a:ext cx="693004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b="1" dirty="0">
                <a:latin typeface="+mj-lt"/>
              </a:rPr>
              <a:t>Fig S11. The Venn diagram of DEGs between </a:t>
            </a:r>
            <a:r>
              <a:rPr lang="en-US" altLang="zh-CN" sz="1400" b="1" i="1" dirty="0">
                <a:latin typeface="+mj-lt"/>
              </a:rPr>
              <a:t>gln2</a:t>
            </a:r>
            <a:r>
              <a:rPr lang="en-US" altLang="zh-CN" sz="1400" b="1" dirty="0">
                <a:latin typeface="+mj-lt"/>
              </a:rPr>
              <a:t> mutant and wild-type plants under  CK and salt conditions</a:t>
            </a:r>
            <a:endParaRPr lang="zh-CN" altLang="en-US" sz="1400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253524161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B177B2C6-6D6F-7163-984D-FF8E7B99635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0760" y="2285999"/>
            <a:ext cx="7778542" cy="5759477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1A445D1D-C1E9-BA93-D060-9047BAF279E8}"/>
              </a:ext>
            </a:extLst>
          </p:cNvPr>
          <p:cNvSpPr txBox="1"/>
          <p:nvPr/>
        </p:nvSpPr>
        <p:spPr>
          <a:xfrm>
            <a:off x="688179" y="8045476"/>
            <a:ext cx="6969921" cy="7000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127000" algn="just">
              <a:lnSpc>
                <a:spcPct val="150000"/>
              </a:lnSpc>
            </a:pP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Fig S12. Expression levels of genes involved in proline metabolism in </a:t>
            </a:r>
            <a:r>
              <a:rPr lang="en-US" altLang="zh-CN" sz="1400" b="1" i="1" kern="100" dirty="0">
                <a:effectLst/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gln2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 mutant compared with wild-type plants in CK and salt conditions.</a:t>
            </a:r>
            <a:endParaRPr lang="zh-CN" altLang="zh-CN" sz="1400" b="1" kern="100" dirty="0">
              <a:effectLst/>
              <a:latin typeface="Times New Roman" panose="02020603050405020304" pitchFamily="18" charset="0"/>
              <a:ea typeface="楷体" panose="02010609060101010101" pitchFamily="49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381483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318F20AB-2A85-BC3B-926E-DD892C5D7146}"/>
              </a:ext>
            </a:extLst>
          </p:cNvPr>
          <p:cNvSpPr txBox="1"/>
          <p:nvPr/>
        </p:nvSpPr>
        <p:spPr>
          <a:xfrm>
            <a:off x="837689" y="7174523"/>
            <a:ext cx="647817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+mj-lt"/>
              </a:rPr>
              <a:t>Fig S2. Temporal clustering of 5331 SSET genes. </a:t>
            </a:r>
          </a:p>
          <a:p>
            <a:r>
              <a:rPr lang="en-US" altLang="zh-CN" sz="1400" dirty="0">
                <a:latin typeface="+mj-lt"/>
              </a:rPr>
              <a:t>(a) the heat map of expression ratio;</a:t>
            </a:r>
            <a:r>
              <a:rPr lang="zh-CN" altLang="en-US" sz="1400" dirty="0">
                <a:latin typeface="+mj-lt"/>
              </a:rPr>
              <a:t> </a:t>
            </a:r>
            <a:r>
              <a:rPr lang="en-US" altLang="zh-CN" sz="1400" dirty="0">
                <a:latin typeface="+mj-lt"/>
              </a:rPr>
              <a:t>(b)</a:t>
            </a:r>
            <a:r>
              <a:rPr lang="zh-CN" altLang="en-US" sz="1400" dirty="0">
                <a:latin typeface="+mj-lt"/>
              </a:rPr>
              <a:t> </a:t>
            </a:r>
            <a:r>
              <a:rPr lang="en-US" altLang="zh-CN" sz="1400" dirty="0">
                <a:latin typeface="+mj-lt"/>
              </a:rPr>
              <a:t>Expression pattern of each cluster.</a:t>
            </a:r>
            <a:endParaRPr lang="zh-CN" altLang="en-US" sz="1400" dirty="0">
              <a:latin typeface="+mj-lt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6902B8B1-5280-59FC-4434-7627759F3F0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" y="922883"/>
            <a:ext cx="8120063" cy="62516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598583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图片包含 图表&#10;&#10;描述已自动生成">
            <a:extLst>
              <a:ext uri="{FF2B5EF4-FFF2-40B4-BE49-F238E27FC236}">
                <a16:creationId xmlns:a16="http://schemas.microsoft.com/office/drawing/2014/main" id="{612EE70F-A07B-64A7-FA64-F03C197DFD2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1578" y="2098849"/>
            <a:ext cx="6768245" cy="4970165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DED08D3D-C0F3-3827-0C67-8925EEB56750}"/>
              </a:ext>
            </a:extLst>
          </p:cNvPr>
          <p:cNvSpPr txBox="1"/>
          <p:nvPr/>
        </p:nvSpPr>
        <p:spPr>
          <a:xfrm>
            <a:off x="820945" y="7069014"/>
            <a:ext cx="6478172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b="1" dirty="0">
                <a:latin typeface="+mj-lt"/>
              </a:rPr>
              <a:t>Fig S3. Generation of </a:t>
            </a:r>
            <a:r>
              <a:rPr lang="en-US" altLang="zh-CN" sz="1400" b="1" i="1" dirty="0">
                <a:latin typeface="+mj-lt"/>
              </a:rPr>
              <a:t>ZmGLK44</a:t>
            </a:r>
            <a:r>
              <a:rPr lang="en-US" altLang="zh-CN" sz="1400" b="1" dirty="0">
                <a:latin typeface="+mj-lt"/>
              </a:rPr>
              <a:t> Crispr and transgenic line. </a:t>
            </a:r>
          </a:p>
          <a:p>
            <a:pPr algn="just"/>
            <a:r>
              <a:rPr lang="en-US" altLang="zh-CN" sz="1400" dirty="0">
                <a:latin typeface="+mj-lt"/>
              </a:rPr>
              <a:t>(a) Generation of ZmGLK44 mutations by CRISPR/Cas9 using two independent single-guide RNAs (gRNA1 and gRNA2). Sequences of </a:t>
            </a:r>
            <a:r>
              <a:rPr lang="en-US" altLang="zh-CN" sz="1400" i="1" dirty="0">
                <a:latin typeface="+mj-lt"/>
              </a:rPr>
              <a:t>ZmGLK44</a:t>
            </a:r>
            <a:r>
              <a:rPr lang="en-US" altLang="zh-CN" sz="1400" dirty="0">
                <a:latin typeface="+mj-lt"/>
              </a:rPr>
              <a:t> KO-26# and KO-44# are shown. sgRNA targets and a protospacer-adjacent motif (PAM) are indicated in red and in blue, respectively. Deletions and insertions are indicated by dashes and in blue, respectively.</a:t>
            </a:r>
            <a:r>
              <a:rPr lang="zh-CN" altLang="en-US" sz="1400" dirty="0">
                <a:latin typeface="+mj-lt"/>
              </a:rPr>
              <a:t> </a:t>
            </a:r>
            <a:r>
              <a:rPr lang="en-US" altLang="zh-CN" sz="1400" dirty="0">
                <a:latin typeface="+mj-lt"/>
              </a:rPr>
              <a:t>(b)</a:t>
            </a:r>
            <a:r>
              <a:rPr lang="zh-CN" altLang="en-US" sz="1400" dirty="0">
                <a:latin typeface="+mj-lt"/>
              </a:rPr>
              <a:t> </a:t>
            </a:r>
            <a:r>
              <a:rPr lang="en-US" altLang="zh-CN" sz="1400" dirty="0">
                <a:latin typeface="+mj-lt"/>
              </a:rPr>
              <a:t>Temporal expression profile of </a:t>
            </a:r>
            <a:r>
              <a:rPr lang="en-US" altLang="zh-CN" sz="1400" i="1" dirty="0">
                <a:latin typeface="+mj-lt"/>
              </a:rPr>
              <a:t>ZmRD101</a:t>
            </a:r>
            <a:r>
              <a:rPr lang="en-US" altLang="zh-CN" sz="1400" dirty="0">
                <a:latin typeface="+mj-lt"/>
              </a:rPr>
              <a:t>.</a:t>
            </a:r>
            <a:r>
              <a:rPr lang="zh-CN" altLang="en-US" sz="1400" dirty="0">
                <a:latin typeface="+mj-lt"/>
              </a:rPr>
              <a:t> </a:t>
            </a:r>
            <a:r>
              <a:rPr lang="en-US" altLang="zh-CN" sz="1400" dirty="0">
                <a:latin typeface="+mj-lt"/>
              </a:rPr>
              <a:t>(c) Diagram showing the expression cassette of </a:t>
            </a:r>
            <a:r>
              <a:rPr lang="en-US" altLang="zh-CN" sz="1400" i="1" dirty="0">
                <a:latin typeface="+mj-lt"/>
              </a:rPr>
              <a:t>ZmGLK44-3HA</a:t>
            </a:r>
            <a:r>
              <a:rPr lang="en-US" altLang="zh-CN" sz="1400" dirty="0">
                <a:latin typeface="+mj-lt"/>
              </a:rPr>
              <a:t> controlled by the promoter of </a:t>
            </a:r>
            <a:r>
              <a:rPr lang="en-US" altLang="zh-CN" sz="1400" i="1" dirty="0">
                <a:latin typeface="+mj-lt"/>
              </a:rPr>
              <a:t>ZmRD101</a:t>
            </a:r>
            <a:r>
              <a:rPr lang="en-US" altLang="zh-CN" sz="1400" dirty="0">
                <a:latin typeface="+mj-lt"/>
              </a:rPr>
              <a:t>; (b) the expression level of </a:t>
            </a:r>
            <a:r>
              <a:rPr lang="en-US" altLang="zh-CN" sz="1400" i="1" dirty="0">
                <a:latin typeface="+mj-lt"/>
              </a:rPr>
              <a:t>ZmGLK44-3HA</a:t>
            </a:r>
            <a:r>
              <a:rPr lang="en-US" altLang="zh-CN" sz="1400" dirty="0">
                <a:latin typeface="+mj-lt"/>
              </a:rPr>
              <a:t> in the positive transgenic lines 1(+) and 10(+) and their related segregated negative siblings 1(-) and 10(-). The primers used in the expression analysis were shown in (c).</a:t>
            </a:r>
          </a:p>
        </p:txBody>
      </p:sp>
    </p:spTree>
    <p:extLst>
      <p:ext uri="{BB962C8B-B14F-4D97-AF65-F5344CB8AC3E}">
        <p14:creationId xmlns:p14="http://schemas.microsoft.com/office/powerpoint/2010/main" val="30420147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250AD5A0-47BC-01F8-5DC9-471C6ECF1AD2}"/>
              </a:ext>
            </a:extLst>
          </p:cNvPr>
          <p:cNvSpPr txBox="1"/>
          <p:nvPr/>
        </p:nvSpPr>
        <p:spPr>
          <a:xfrm>
            <a:off x="974118" y="6801730"/>
            <a:ext cx="64781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+mj-lt"/>
              </a:rPr>
              <a:t>Fig S4. The metabolic profiles of proline (upper) and myo-inositol (bottom).</a:t>
            </a:r>
            <a:endParaRPr lang="en-US" altLang="zh-CN" sz="1400" dirty="0">
              <a:latin typeface="+mj-lt"/>
            </a:endParaRPr>
          </a:p>
        </p:txBody>
      </p:sp>
      <p:pic>
        <p:nvPicPr>
          <p:cNvPr id="29" name="图片 28">
            <a:extLst>
              <a:ext uri="{FF2B5EF4-FFF2-40B4-BE49-F238E27FC236}">
                <a16:creationId xmlns:a16="http://schemas.microsoft.com/office/drawing/2014/main" id="{7ED093C5-3795-9AB1-BF99-C05A18FF42E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7287" y="1089283"/>
            <a:ext cx="7925487" cy="57124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8514511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363E2BA5-6768-EEA2-54FD-0F9EF37D2FC9}"/>
              </a:ext>
            </a:extLst>
          </p:cNvPr>
          <p:cNvSpPr txBox="1"/>
          <p:nvPr/>
        </p:nvSpPr>
        <p:spPr>
          <a:xfrm>
            <a:off x="841101" y="5342063"/>
            <a:ext cx="64781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+mj-lt"/>
              </a:rPr>
              <a:t>Fig S5. Temporal expression profile of MIPS-coding genes in HLZY and JI853  </a:t>
            </a:r>
            <a:endParaRPr lang="en-US" altLang="zh-CN" sz="1400" dirty="0">
              <a:latin typeface="+mj-lt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84526EC4-514C-9EB5-B815-8F2AFBE3A16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337" y="3073265"/>
            <a:ext cx="8120063" cy="21339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027857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图表, 散点图&#10;&#10;描述已自动生成">
            <a:extLst>
              <a:ext uri="{FF2B5EF4-FFF2-40B4-BE49-F238E27FC236}">
                <a16:creationId xmlns:a16="http://schemas.microsoft.com/office/drawing/2014/main" id="{03B561C8-FDEB-93BD-C22B-24E208E470D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3054" y="2691569"/>
            <a:ext cx="7186190" cy="4089058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D053E777-C954-BF07-C8BA-097FC15DA2C9}"/>
              </a:ext>
            </a:extLst>
          </p:cNvPr>
          <p:cNvSpPr txBox="1"/>
          <p:nvPr/>
        </p:nvSpPr>
        <p:spPr>
          <a:xfrm>
            <a:off x="763728" y="6833238"/>
            <a:ext cx="64781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+mj-lt"/>
              </a:rPr>
              <a:t>Fig S6. Prediction accuracy of all 310 detected metabolites.</a:t>
            </a:r>
            <a:endParaRPr lang="en-US" altLang="zh-CN" sz="1400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278799272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74878D4E-2387-D5ED-DE26-AAD8B43C8666}"/>
              </a:ext>
            </a:extLst>
          </p:cNvPr>
          <p:cNvSpPr txBox="1"/>
          <p:nvPr/>
        </p:nvSpPr>
        <p:spPr>
          <a:xfrm>
            <a:off x="921456" y="9571786"/>
            <a:ext cx="6478172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+mj-lt"/>
              </a:rPr>
              <a:t>Fig S7. Phylogenic analysis and temporal expression profile of 6 GLN-coding genes in maize. </a:t>
            </a:r>
          </a:p>
          <a:p>
            <a:r>
              <a:rPr lang="en-US" altLang="zh-CN" sz="1400" dirty="0">
                <a:latin typeface="+mj-lt"/>
              </a:rPr>
              <a:t>(a) The phylogenetic analysis;</a:t>
            </a:r>
            <a:r>
              <a:rPr lang="zh-CN" altLang="en-US" sz="1400" dirty="0">
                <a:latin typeface="+mj-lt"/>
              </a:rPr>
              <a:t> </a:t>
            </a:r>
            <a:r>
              <a:rPr lang="en-US" altLang="zh-CN" sz="1400" dirty="0">
                <a:latin typeface="+mj-lt"/>
              </a:rPr>
              <a:t>(b)</a:t>
            </a:r>
            <a:r>
              <a:rPr lang="zh-CN" altLang="en-US" sz="1400" dirty="0">
                <a:latin typeface="+mj-lt"/>
              </a:rPr>
              <a:t> </a:t>
            </a:r>
            <a:r>
              <a:rPr lang="en-US" altLang="zh-CN" sz="1400" dirty="0">
                <a:latin typeface="+mj-lt"/>
              </a:rPr>
              <a:t>The temporal expression profile.</a:t>
            </a:r>
            <a:endParaRPr lang="zh-CN" altLang="en-US" sz="1400" dirty="0">
              <a:latin typeface="+mj-lt"/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3DC07C83-ED59-3D58-BD0C-CF0CE8C3AE4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0921" y="254826"/>
            <a:ext cx="7218220" cy="89719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8439446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图表&#10;&#10;描述已自动生成">
            <a:extLst>
              <a:ext uri="{FF2B5EF4-FFF2-40B4-BE49-F238E27FC236}">
                <a16:creationId xmlns:a16="http://schemas.microsoft.com/office/drawing/2014/main" id="{C9C44CBD-E71C-3A13-FF2C-78D3D7C3AD4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76039" y="3051098"/>
            <a:ext cx="6302466" cy="3096482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41AEAB2D-96E6-0C27-C604-941A44406231}"/>
              </a:ext>
            </a:extLst>
          </p:cNvPr>
          <p:cNvSpPr txBox="1"/>
          <p:nvPr/>
        </p:nvSpPr>
        <p:spPr>
          <a:xfrm>
            <a:off x="988186" y="6260124"/>
            <a:ext cx="6478172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+mj-lt"/>
              </a:rPr>
              <a:t>Fig S8. Identification of </a:t>
            </a:r>
            <a:r>
              <a:rPr lang="en-US" altLang="zh-CN" sz="1400" b="1" i="1" dirty="0">
                <a:latin typeface="+mj-lt"/>
              </a:rPr>
              <a:t>ZmGLN2</a:t>
            </a:r>
            <a:r>
              <a:rPr lang="en-US" altLang="zh-CN" sz="1400" b="1" dirty="0">
                <a:latin typeface="+mj-lt"/>
              </a:rPr>
              <a:t> stop-gained mutant in maize EMS bank.</a:t>
            </a:r>
          </a:p>
          <a:p>
            <a:r>
              <a:rPr lang="en-US" altLang="zh-CN" sz="1400" dirty="0">
                <a:latin typeface="+mj-lt"/>
              </a:rPr>
              <a:t>The primer used for </a:t>
            </a:r>
            <a:r>
              <a:rPr lang="en-US" altLang="zh-CN" sz="1400" i="1" dirty="0">
                <a:latin typeface="+mj-lt"/>
              </a:rPr>
              <a:t>zmgln2</a:t>
            </a:r>
            <a:r>
              <a:rPr lang="en-US" altLang="zh-CN" sz="1400" dirty="0">
                <a:latin typeface="+mj-lt"/>
              </a:rPr>
              <a:t> fragments amplifying and sanger sequencing is shown in Table S10.</a:t>
            </a:r>
          </a:p>
        </p:txBody>
      </p:sp>
    </p:spTree>
    <p:extLst>
      <p:ext uri="{BB962C8B-B14F-4D97-AF65-F5344CB8AC3E}">
        <p14:creationId xmlns:p14="http://schemas.microsoft.com/office/powerpoint/2010/main" val="10357216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图片 42">
            <a:extLst>
              <a:ext uri="{FF2B5EF4-FFF2-40B4-BE49-F238E27FC236}">
                <a16:creationId xmlns:a16="http://schemas.microsoft.com/office/drawing/2014/main" id="{2F985A80-A0EC-92D9-70C0-BEB3D14BD21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33643" y="1647531"/>
            <a:ext cx="8120063" cy="6279664"/>
          </a:xfrm>
          <a:prstGeom prst="rect">
            <a:avLst/>
          </a:prstGeom>
        </p:spPr>
      </p:pic>
      <p:sp>
        <p:nvSpPr>
          <p:cNvPr id="44" name="文本框 43">
            <a:extLst>
              <a:ext uri="{FF2B5EF4-FFF2-40B4-BE49-F238E27FC236}">
                <a16:creationId xmlns:a16="http://schemas.microsoft.com/office/drawing/2014/main" id="{66D68AD7-044C-DC18-9AD6-F21D8E310596}"/>
              </a:ext>
            </a:extLst>
          </p:cNvPr>
          <p:cNvSpPr txBox="1"/>
          <p:nvPr/>
        </p:nvSpPr>
        <p:spPr>
          <a:xfrm>
            <a:off x="1424285" y="8138161"/>
            <a:ext cx="6478172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+mj-lt"/>
              </a:rPr>
              <a:t>Fig S9. Na</a:t>
            </a:r>
            <a:r>
              <a:rPr lang="en-US" altLang="zh-CN" sz="1400" b="1" baseline="30000" dirty="0">
                <a:latin typeface="+mj-lt"/>
              </a:rPr>
              <a:t>+</a:t>
            </a:r>
            <a:r>
              <a:rPr lang="en-US" altLang="zh-CN" sz="1400" b="1" dirty="0">
                <a:latin typeface="+mj-lt"/>
              </a:rPr>
              <a:t> levels, K</a:t>
            </a:r>
            <a:r>
              <a:rPr lang="en-US" altLang="zh-CN" sz="1400" b="1" baseline="30000" dirty="0">
                <a:latin typeface="+mj-lt"/>
              </a:rPr>
              <a:t>+</a:t>
            </a:r>
            <a:r>
              <a:rPr lang="en-US" altLang="zh-CN" sz="1400" b="1" dirty="0">
                <a:latin typeface="+mj-lt"/>
              </a:rPr>
              <a:t> levels, and Na</a:t>
            </a:r>
            <a:r>
              <a:rPr lang="en-US" altLang="zh-CN" sz="1400" b="1" baseline="30000" dirty="0">
                <a:latin typeface="+mj-lt"/>
              </a:rPr>
              <a:t>+</a:t>
            </a:r>
            <a:r>
              <a:rPr lang="en-US" altLang="zh-CN" sz="1400" b="1" dirty="0">
                <a:latin typeface="+mj-lt"/>
              </a:rPr>
              <a:t>/K</a:t>
            </a:r>
            <a:r>
              <a:rPr lang="en-US" altLang="zh-CN" sz="1400" b="1" baseline="30000" dirty="0">
                <a:latin typeface="+mj-lt"/>
              </a:rPr>
              <a:t>+</a:t>
            </a:r>
            <a:r>
              <a:rPr lang="en-US" altLang="zh-CN" sz="1400" b="1" dirty="0">
                <a:latin typeface="+mj-lt"/>
              </a:rPr>
              <a:t> ratio change among </a:t>
            </a:r>
            <a:r>
              <a:rPr lang="en-US" altLang="zh-CN" sz="1400" b="1" i="1" dirty="0">
                <a:latin typeface="+mj-lt"/>
              </a:rPr>
              <a:t>ZmGLK44 </a:t>
            </a:r>
            <a:r>
              <a:rPr lang="en-US" altLang="zh-CN" sz="1400" b="1" dirty="0">
                <a:latin typeface="+mj-lt"/>
              </a:rPr>
              <a:t>OE, KO, and wild-type plants under CK (a - c) and salt stress (d – f) conditions. </a:t>
            </a:r>
            <a:r>
              <a:rPr lang="en-US" altLang="zh-CN" sz="1400" dirty="0">
                <a:latin typeface="+mj-lt"/>
              </a:rPr>
              <a:t>Error bar: stand deviation; Statistical significance was determined by one-way </a:t>
            </a:r>
            <a:r>
              <a:rPr lang="en-US" altLang="zh-CN" sz="1400" dirty="0" err="1">
                <a:latin typeface="+mj-lt"/>
              </a:rPr>
              <a:t>anova</a:t>
            </a:r>
            <a:r>
              <a:rPr lang="en-US" altLang="zh-CN" sz="1400" dirty="0">
                <a:latin typeface="+mj-lt"/>
              </a:rPr>
              <a:t> and Tukey’s multiple </a:t>
            </a:r>
            <a:r>
              <a:rPr lang="en-US" altLang="zh-CN" sz="1400" dirty="0" err="1">
                <a:latin typeface="+mj-lt"/>
              </a:rPr>
              <a:t>comprations</a:t>
            </a:r>
            <a:r>
              <a:rPr lang="en-US" altLang="zh-CN" sz="1400" dirty="0">
                <a:latin typeface="+mj-lt"/>
              </a:rPr>
              <a:t> test with each other with alpha as 0.05.</a:t>
            </a:r>
          </a:p>
        </p:txBody>
      </p:sp>
    </p:spTree>
    <p:extLst>
      <p:ext uri="{BB962C8B-B14F-4D97-AF65-F5344CB8AC3E}">
        <p14:creationId xmlns:p14="http://schemas.microsoft.com/office/powerpoint/2010/main" val="25809415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imes New Roman-Arial">
      <a:majorFont>
        <a:latin typeface="Times New Roman" panose="02020603050405020304"/>
        <a:ea typeface=""/>
        <a:cs typeface=""/>
        <a:font script="Jpan" typeface="ＭＳ Ｐ明朝"/>
        <a:font script="Hang" typeface="바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돋움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035</TotalTime>
  <Words>460</Words>
  <Application>Microsoft Office PowerPoint</Application>
  <PresentationFormat>B4 (ISO)纸张(250x353 毫米)</PresentationFormat>
  <Paragraphs>16</Paragraphs>
  <Slides>1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2</vt:i4>
      </vt:variant>
    </vt:vector>
  </HeadingPairs>
  <TitlesOfParts>
    <vt:vector size="15" baseType="lpstr"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Zhang Fei</dc:creator>
  <cp:lastModifiedBy>Zhang Fei</cp:lastModifiedBy>
  <cp:revision>2</cp:revision>
  <dcterms:created xsi:type="dcterms:W3CDTF">2024-12-25T13:16:47Z</dcterms:created>
  <dcterms:modified xsi:type="dcterms:W3CDTF">2025-08-10T08:07:21Z</dcterms:modified>
</cp:coreProperties>
</file>